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64" r:id="rId2"/>
    <p:sldId id="259" r:id="rId3"/>
    <p:sldId id="257" r:id="rId4"/>
    <p:sldId id="261" r:id="rId5"/>
    <p:sldId id="262" r:id="rId6"/>
  </p:sldIdLst>
  <p:sldSz cx="6858000" cy="9906000" type="A4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恒" initials="恒" lastIdx="1" clrIdx="0">
    <p:extLst>
      <p:ext uri="{19B8F6BF-5375-455C-9EA6-DF929625EA0E}">
        <p15:presenceInfo xmlns:p15="http://schemas.microsoft.com/office/powerpoint/2012/main" userId="d402efd5e3ed7b6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0814691-0BA1-487D-BE4D-74926A73B87C}" v="12" dt="2021-07-25T05:50:49.2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2" d="100"/>
          <a:sy n="52" d="100"/>
        </p:scale>
        <p:origin x="198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廣瀬 恒" userId="d402efd5e3ed7b6b" providerId="LiveId" clId="{20814691-0BA1-487D-BE4D-74926A73B87C}"/>
    <pc:docChg chg="custSel addSld delSld modSld">
      <pc:chgData name="廣瀬 恒" userId="d402efd5e3ed7b6b" providerId="LiveId" clId="{20814691-0BA1-487D-BE4D-74926A73B87C}" dt="2021-07-25T05:50:49.258" v="59"/>
      <pc:docMkLst>
        <pc:docMk/>
      </pc:docMkLst>
      <pc:sldChg chg="modSp">
        <pc:chgData name="廣瀬 恒" userId="d402efd5e3ed7b6b" providerId="LiveId" clId="{20814691-0BA1-487D-BE4D-74926A73B87C}" dt="2021-07-25T05:50:05.221" v="56" actId="207"/>
        <pc:sldMkLst>
          <pc:docMk/>
          <pc:sldMk cId="1175077341" sldId="257"/>
        </pc:sldMkLst>
        <pc:graphicFrameChg chg="mod">
          <ac:chgData name="廣瀬 恒" userId="d402efd5e3ed7b6b" providerId="LiveId" clId="{20814691-0BA1-487D-BE4D-74926A73B87C}" dt="2021-07-25T05:50:05.221" v="56" actId="207"/>
          <ac:graphicFrameMkLst>
            <pc:docMk/>
            <pc:sldMk cId="1175077341" sldId="257"/>
            <ac:graphicFrameMk id="21" creationId="{501F6449-FC17-4A19-955A-F64C2D89F0D8}"/>
          </ac:graphicFrameMkLst>
        </pc:graphicFrameChg>
      </pc:sldChg>
      <pc:sldChg chg="addSp delSp modSp mod">
        <pc:chgData name="廣瀬 恒" userId="d402efd5e3ed7b6b" providerId="LiveId" clId="{20814691-0BA1-487D-BE4D-74926A73B87C}" dt="2021-07-25T05:50:49.258" v="59"/>
        <pc:sldMkLst>
          <pc:docMk/>
          <pc:sldMk cId="951431837" sldId="261"/>
        </pc:sldMkLst>
        <pc:spChg chg="mod">
          <ac:chgData name="廣瀬 恒" userId="d402efd5e3ed7b6b" providerId="LiveId" clId="{20814691-0BA1-487D-BE4D-74926A73B87C}" dt="2021-07-23T07:15:33.245" v="30" actId="20577"/>
          <ac:spMkLst>
            <pc:docMk/>
            <pc:sldMk cId="951431837" sldId="261"/>
            <ac:spMk id="2" creationId="{D0C61B46-DD40-445D-9C6F-29264D41C13A}"/>
          </ac:spMkLst>
        </pc:spChg>
        <pc:graphicFrameChg chg="del">
          <ac:chgData name="廣瀬 恒" userId="d402efd5e3ed7b6b" providerId="LiveId" clId="{20814691-0BA1-487D-BE4D-74926A73B87C}" dt="2021-07-23T13:36:15.371" v="33" actId="478"/>
          <ac:graphicFrameMkLst>
            <pc:docMk/>
            <pc:sldMk cId="951431837" sldId="261"/>
            <ac:graphicFrameMk id="6" creationId="{9526692A-2F4B-49FF-ABE0-41173F4F2257}"/>
          </ac:graphicFrameMkLst>
        </pc:graphicFrameChg>
        <pc:graphicFrameChg chg="del">
          <ac:chgData name="廣瀬 恒" userId="d402efd5e3ed7b6b" providerId="LiveId" clId="{20814691-0BA1-487D-BE4D-74926A73B87C}" dt="2021-07-23T13:38:59.738" v="43" actId="478"/>
          <ac:graphicFrameMkLst>
            <pc:docMk/>
            <pc:sldMk cId="951431837" sldId="261"/>
            <ac:graphicFrameMk id="7" creationId="{336FFC53-9DBD-49ED-93E8-715DB474CAC3}"/>
          </ac:graphicFrameMkLst>
        </pc:graphicFrameChg>
        <pc:graphicFrameChg chg="add mod">
          <ac:chgData name="廣瀬 恒" userId="d402efd5e3ed7b6b" providerId="LiveId" clId="{20814691-0BA1-487D-BE4D-74926A73B87C}" dt="2021-07-25T05:50:33.589" v="57" actId="207"/>
          <ac:graphicFrameMkLst>
            <pc:docMk/>
            <pc:sldMk cId="951431837" sldId="261"/>
            <ac:graphicFrameMk id="10" creationId="{9526692A-2F4B-49FF-ABE0-41173F4F2257}"/>
          </ac:graphicFrameMkLst>
        </pc:graphicFrameChg>
        <pc:graphicFrameChg chg="add mod">
          <ac:chgData name="廣瀬 恒" userId="d402efd5e3ed7b6b" providerId="LiveId" clId="{20814691-0BA1-487D-BE4D-74926A73B87C}" dt="2021-07-25T05:50:49.258" v="59"/>
          <ac:graphicFrameMkLst>
            <pc:docMk/>
            <pc:sldMk cId="951431837" sldId="261"/>
            <ac:graphicFrameMk id="11" creationId="{336FFC53-9DBD-49ED-93E8-715DB474CAC3}"/>
          </ac:graphicFrameMkLst>
        </pc:graphicFrameChg>
      </pc:sldChg>
      <pc:sldChg chg="modSp mod">
        <pc:chgData name="廣瀬 恒" userId="d402efd5e3ed7b6b" providerId="LiveId" clId="{20814691-0BA1-487D-BE4D-74926A73B87C}" dt="2021-07-23T07:15:58.928" v="32" actId="20577"/>
        <pc:sldMkLst>
          <pc:docMk/>
          <pc:sldMk cId="4061429946" sldId="262"/>
        </pc:sldMkLst>
        <pc:spChg chg="mod">
          <ac:chgData name="廣瀬 恒" userId="d402efd5e3ed7b6b" providerId="LiveId" clId="{20814691-0BA1-487D-BE4D-74926A73B87C}" dt="2021-07-23T07:15:58.928" v="32" actId="20577"/>
          <ac:spMkLst>
            <pc:docMk/>
            <pc:sldMk cId="4061429946" sldId="262"/>
            <ac:spMk id="4" creationId="{D045FC19-EF0C-4ECC-8E10-8626B3FD7EB9}"/>
          </ac:spMkLst>
        </pc:spChg>
      </pc:sldChg>
      <pc:sldChg chg="modSp">
        <pc:chgData name="廣瀬 恒" userId="d402efd5e3ed7b6b" providerId="LiveId" clId="{20814691-0BA1-487D-BE4D-74926A73B87C}" dt="2021-07-25T05:49:35.212" v="55" actId="207"/>
        <pc:sldMkLst>
          <pc:docMk/>
          <pc:sldMk cId="3914364136" sldId="264"/>
        </pc:sldMkLst>
        <pc:graphicFrameChg chg="mod">
          <ac:chgData name="廣瀬 恒" userId="d402efd5e3ed7b6b" providerId="LiveId" clId="{20814691-0BA1-487D-BE4D-74926A73B87C}" dt="2021-07-25T05:49:35.212" v="55" actId="207"/>
          <ac:graphicFrameMkLst>
            <pc:docMk/>
            <pc:sldMk cId="3914364136" sldId="264"/>
            <ac:graphicFrameMk id="22" creationId="{E091C523-E980-4F17-B002-4C3518AB512E}"/>
          </ac:graphicFrameMkLst>
        </pc:graphicFrameChg>
      </pc:sldChg>
      <pc:sldChg chg="new del">
        <pc:chgData name="廣瀬 恒" userId="d402efd5e3ed7b6b" providerId="LiveId" clId="{20814691-0BA1-487D-BE4D-74926A73B87C}" dt="2021-07-20T13:24:20.633" v="21" actId="2696"/>
        <pc:sldMkLst>
          <pc:docMk/>
          <pc:sldMk cId="3909502882" sldId="265"/>
        </pc:sldMkLst>
      </pc:sldChg>
      <pc:sldChg chg="modSp add del mod">
        <pc:chgData name="廣瀬 恒" userId="d402efd5e3ed7b6b" providerId="LiveId" clId="{20814691-0BA1-487D-BE4D-74926A73B87C}" dt="2021-07-23T07:15:08.314" v="26" actId="2696"/>
        <pc:sldMkLst>
          <pc:docMk/>
          <pc:sldMk cId="4027168830" sldId="266"/>
        </pc:sldMkLst>
        <pc:spChg chg="mod">
          <ac:chgData name="廣瀬 恒" userId="d402efd5e3ed7b6b" providerId="LiveId" clId="{20814691-0BA1-487D-BE4D-74926A73B87C}" dt="2021-07-20T13:23:57.602" v="20" actId="20577"/>
          <ac:spMkLst>
            <pc:docMk/>
            <pc:sldMk cId="4027168830" sldId="266"/>
            <ac:spMk id="4" creationId="{29BBA8DB-8208-4CA4-B9B0-24DE1D11C1E2}"/>
          </ac:spMkLst>
        </pc:spChg>
      </pc:sldChg>
    </pc:docChg>
  </pc:docChgLst>
  <pc:docChgLst>
    <pc:chgData name="廣瀬 恒" userId="d402efd5e3ed7b6b" providerId="LiveId" clId="{9AB8AEE1-63B9-4559-BBE2-67C86C987165}"/>
    <pc:docChg chg="custSel modSld">
      <pc:chgData name="廣瀬 恒" userId="d402efd5e3ed7b6b" providerId="LiveId" clId="{9AB8AEE1-63B9-4559-BBE2-67C86C987165}" dt="2021-06-27T10:44:00.670" v="19"/>
      <pc:docMkLst>
        <pc:docMk/>
      </pc:docMkLst>
      <pc:sldChg chg="addSp delSp modSp mod">
        <pc:chgData name="廣瀬 恒" userId="d402efd5e3ed7b6b" providerId="LiveId" clId="{9AB8AEE1-63B9-4559-BBE2-67C86C987165}" dt="2021-06-27T10:44:00.670" v="19"/>
        <pc:sldMkLst>
          <pc:docMk/>
          <pc:sldMk cId="951431837" sldId="261"/>
        </pc:sldMkLst>
        <pc:graphicFrameChg chg="add mod">
          <ac:chgData name="廣瀬 恒" userId="d402efd5e3ed7b6b" providerId="LiveId" clId="{9AB8AEE1-63B9-4559-BBE2-67C86C987165}" dt="2021-06-27T10:40:50.438" v="9" actId="255"/>
          <ac:graphicFrameMkLst>
            <pc:docMk/>
            <pc:sldMk cId="951431837" sldId="261"/>
            <ac:graphicFrameMk id="6" creationId="{9526692A-2F4B-49FF-ABE0-41173F4F2257}"/>
          </ac:graphicFrameMkLst>
        </pc:graphicFrameChg>
        <pc:graphicFrameChg chg="add mod">
          <ac:chgData name="廣瀬 恒" userId="d402efd5e3ed7b6b" providerId="LiveId" clId="{9AB8AEE1-63B9-4559-BBE2-67C86C987165}" dt="2021-06-27T10:44:00.670" v="19"/>
          <ac:graphicFrameMkLst>
            <pc:docMk/>
            <pc:sldMk cId="951431837" sldId="261"/>
            <ac:graphicFrameMk id="7" creationId="{336FFC53-9DBD-49ED-93E8-715DB474CAC3}"/>
          </ac:graphicFrameMkLst>
        </pc:graphicFrameChg>
        <pc:graphicFrameChg chg="del">
          <ac:chgData name="廣瀬 恒" userId="d402efd5e3ed7b6b" providerId="LiveId" clId="{9AB8AEE1-63B9-4559-BBE2-67C86C987165}" dt="2021-06-27T10:38:36.204" v="0" actId="478"/>
          <ac:graphicFrameMkLst>
            <pc:docMk/>
            <pc:sldMk cId="951431837" sldId="261"/>
            <ac:graphicFrameMk id="7" creationId="{9526692A-2F4B-49FF-ABE0-41173F4F2257}"/>
          </ac:graphicFrameMkLst>
        </pc:graphicFrameChg>
        <pc:graphicFrameChg chg="del">
          <ac:chgData name="廣瀬 恒" userId="d402efd5e3ed7b6b" providerId="LiveId" clId="{9AB8AEE1-63B9-4559-BBE2-67C86C987165}" dt="2021-06-27T10:41:01.170" v="10" actId="478"/>
          <ac:graphicFrameMkLst>
            <pc:docMk/>
            <pc:sldMk cId="951431837" sldId="261"/>
            <ac:graphicFrameMk id="10" creationId="{336FFC53-9DBD-49ED-93E8-715DB474CAC3}"/>
          </ac:graphicFrameMkLst>
        </pc:graphicFrameChg>
      </pc:sldChg>
    </pc:docChg>
  </pc:docChgLst>
  <pc:docChgLst>
    <pc:chgData name="廣瀬 恒" userId="d402efd5e3ed7b6b" providerId="LiveId" clId="{36E657FD-B07C-4E85-9DEE-62D4569D04E0}"/>
    <pc:docChg chg="custSel modSld">
      <pc:chgData name="廣瀬 恒" userId="d402efd5e3ed7b6b" providerId="LiveId" clId="{36E657FD-B07C-4E85-9DEE-62D4569D04E0}" dt="2020-12-26T18:32:21.701" v="23" actId="207"/>
      <pc:docMkLst>
        <pc:docMk/>
      </pc:docMkLst>
      <pc:sldChg chg="modSp">
        <pc:chgData name="廣瀬 恒" userId="d402efd5e3ed7b6b" providerId="LiveId" clId="{36E657FD-B07C-4E85-9DEE-62D4569D04E0}" dt="2020-12-26T18:32:21.701" v="23" actId="207"/>
        <pc:sldMkLst>
          <pc:docMk/>
          <pc:sldMk cId="1175077341" sldId="257"/>
        </pc:sldMkLst>
        <pc:graphicFrameChg chg="mod">
          <ac:chgData name="廣瀬 恒" userId="d402efd5e3ed7b6b" providerId="LiveId" clId="{36E657FD-B07C-4E85-9DEE-62D4569D04E0}" dt="2020-12-26T18:32:21.701" v="23" actId="207"/>
          <ac:graphicFrameMkLst>
            <pc:docMk/>
            <pc:sldMk cId="1175077341" sldId="257"/>
            <ac:graphicFrameMk id="22" creationId="{D9280625-4634-467A-8A74-5E0DAE50A8F8}"/>
          </ac:graphicFrameMkLst>
        </pc:graphicFrameChg>
        <pc:graphicFrameChg chg="mod">
          <ac:chgData name="廣瀬 恒" userId="d402efd5e3ed7b6b" providerId="LiveId" clId="{36E657FD-B07C-4E85-9DEE-62D4569D04E0}" dt="2020-12-26T18:32:15.125" v="22" actId="207"/>
          <ac:graphicFrameMkLst>
            <pc:docMk/>
            <pc:sldMk cId="1175077341" sldId="257"/>
            <ac:graphicFrameMk id="24" creationId="{7CB55E5A-899F-49B4-A070-E8EADCF11DF9}"/>
          </ac:graphicFrameMkLst>
        </pc:graphicFrameChg>
      </pc:sldChg>
      <pc:sldChg chg="addSp delSp modSp mod">
        <pc:chgData name="廣瀬 恒" userId="d402efd5e3ed7b6b" providerId="LiveId" clId="{36E657FD-B07C-4E85-9DEE-62D4569D04E0}" dt="2020-12-26T18:31:08.952" v="20" actId="14100"/>
        <pc:sldMkLst>
          <pc:docMk/>
          <pc:sldMk cId="3914364136" sldId="264"/>
        </pc:sldMkLst>
        <pc:spChg chg="add mod">
          <ac:chgData name="廣瀬 恒" userId="d402efd5e3ed7b6b" providerId="LiveId" clId="{36E657FD-B07C-4E85-9DEE-62D4569D04E0}" dt="2020-12-26T18:31:08.952" v="20" actId="14100"/>
          <ac:spMkLst>
            <pc:docMk/>
            <pc:sldMk cId="3914364136" sldId="264"/>
            <ac:spMk id="13" creationId="{4D78F2FD-E4D8-472E-A432-855D31563577}"/>
          </ac:spMkLst>
        </pc:spChg>
        <pc:spChg chg="del">
          <ac:chgData name="廣瀬 恒" userId="d402efd5e3ed7b6b" providerId="LiveId" clId="{36E657FD-B07C-4E85-9DEE-62D4569D04E0}" dt="2020-12-26T18:26:55.834" v="8" actId="478"/>
          <ac:spMkLst>
            <pc:docMk/>
            <pc:sldMk cId="3914364136" sldId="264"/>
            <ac:spMk id="18" creationId="{CC5B5B36-0F1D-42A4-BAC4-ADD87C5FD3B3}"/>
          </ac:spMkLst>
        </pc:spChg>
        <pc:graphicFrameChg chg="del">
          <ac:chgData name="廣瀬 恒" userId="d402efd5e3ed7b6b" providerId="LiveId" clId="{36E657FD-B07C-4E85-9DEE-62D4569D04E0}" dt="2020-12-26T18:24:46.660" v="0" actId="478"/>
          <ac:graphicFrameMkLst>
            <pc:docMk/>
            <pc:sldMk cId="3914364136" sldId="264"/>
            <ac:graphicFrameMk id="9" creationId="{E091C523-E980-4F17-B002-4C3518AB512E}"/>
          </ac:graphicFrameMkLst>
        </pc:graphicFrameChg>
        <pc:graphicFrameChg chg="add mod">
          <ac:chgData name="廣瀬 恒" userId="d402efd5e3ed7b6b" providerId="LiveId" clId="{36E657FD-B07C-4E85-9DEE-62D4569D04E0}" dt="2020-12-26T18:28:25.626" v="13" actId="113"/>
          <ac:graphicFrameMkLst>
            <pc:docMk/>
            <pc:sldMk cId="3914364136" sldId="264"/>
            <ac:graphicFrameMk id="22" creationId="{E091C523-E980-4F17-B002-4C3518AB512E}"/>
          </ac:graphicFrameMkLst>
        </pc:graphicFrameChg>
        <pc:cxnChg chg="add mod">
          <ac:chgData name="廣瀬 恒" userId="d402efd5e3ed7b6b" providerId="LiveId" clId="{36E657FD-B07C-4E85-9DEE-62D4569D04E0}" dt="2020-12-26T18:28:59.998" v="15" actId="13822"/>
          <ac:cxnSpMkLst>
            <pc:docMk/>
            <pc:sldMk cId="3914364136" sldId="264"/>
            <ac:cxnSpMk id="12" creationId="{A860DAA6-0758-46C3-8E48-635C46882065}"/>
          </ac:cxnSpMkLst>
        </pc:cxnChg>
        <pc:cxnChg chg="del">
          <ac:chgData name="廣瀬 恒" userId="d402efd5e3ed7b6b" providerId="LiveId" clId="{36E657FD-B07C-4E85-9DEE-62D4569D04E0}" dt="2020-12-26T18:27:01.161" v="9" actId="478"/>
          <ac:cxnSpMkLst>
            <pc:docMk/>
            <pc:sldMk cId="3914364136" sldId="264"/>
            <ac:cxnSpMk id="17" creationId="{2D970DCC-0B70-4525-885E-13B8C0DFF3F5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DAS28ESR_CDAI_SDAI&#24179;&#22343;&#20516;&#12398;&#25512;&#3122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EULAR%20&#25913;&#21892;&#29575;_HAQ=DI&#35299;&#26512;&#12398;&#12383;&#12417;&#12398;&#12456;&#12463;&#12475;&#12523;&#12487;&#12540;&#12479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PS&#12510;&#12483;&#12481;&#12531;&#12464;&#24460;_SE&#21029;&#35299;&#26512;&#65288;&#21508;&#32676;&#65303;&#65296;&#20363;&#65289;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PS&#12510;&#12483;&#12481;&#12531;&#12464;&#24460;_SE&#21029;&#35299;&#26512;&#65288;&#21508;&#32676;&#65303;&#65296;&#20363;&#65289;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PS&#12510;&#12483;&#12481;&#12531;&#12464;&#24460;_SE&#21029;&#35299;&#26512;&#65288;&#21508;&#32676;&#65303;&#65296;&#20363;&#65289;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PS&#12510;&#12483;&#12481;&#12531;&#12464;&#24460;_SE&#21029;&#35299;&#26512;&#65288;&#21508;&#32676;&#65303;&#65296;&#20363;&#65289;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PS&#12510;&#12483;&#12481;&#12531;&#12464;&#24460;_SE&#21029;&#35299;&#26512;&#65288;&#21508;&#32676;&#65303;&#65296;&#20363;&#65289;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PS&#12510;&#12483;&#12481;&#12531;&#12464;&#24460;_SE&#21029;&#35299;&#26512;&#65288;&#21508;&#32676;&#65303;&#65296;&#20363;&#65289;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d402efd5e3ed7b6b/&#12489;&#12461;&#12517;&#12513;&#12531;&#12488;/TOFABT%20study/TOFABT&#30740;&#31350;&#20013;&#38291;&#35299;&#26512;&#12487;&#12540;&#12479;_ART&#21407;&#31295;/SE&#21029;CDAI_SDAI_DAS28&#23515;&#35299;&#29575;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d402efd5e3ed7b6b/&#12489;&#12461;&#12517;&#12513;&#12531;&#12488;/TOFABT%20study/TOFABT&#30740;&#31350;&#20013;&#38291;&#35299;&#26512;&#12487;&#12540;&#12479;_ART&#21407;&#31295;/SE&#21029;CDAI_SDAI_DAS28&#23515;&#35299;&#29575;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EULAR%20&#25913;&#21892;&#29575;&#35299;&#26512;&#12398;&#12383;&#12417;&#12398;&#12456;&#12463;&#12475;&#12523;&#12487;&#12540;&#12479;%20(version%202).xlsb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CDAI&#25512;&#31227;&#12398;&#35299;&#2651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EULAR%20&#25913;&#21892;&#29575;&#35299;&#26512;&#12398;&#12383;&#12417;&#12398;&#12456;&#12463;&#12475;&#12523;&#12487;&#12540;&#12479;%20(version%202).xlsb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SDAI&#12398;&#25512;&#31227;_&#22793;&#21270;&#37327;_ESR_CRP&#12456;&#12463;&#12475;&#12523;&#12487;&#12540;&#12479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DAS28ESR_CDAI_SDAI&#24179;&#22343;&#20516;&#12398;&#25512;&#31227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DAS28ESR&#25512;&#31227;&#12398;&#35299;&#26512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d402efd5e3ed7b6b/&#12489;&#12461;&#12517;&#12513;&#12531;&#12488;/TOFABT%20study/TOFABT&#30740;&#31350;&#20013;&#38291;&#35299;&#26512;&#12487;&#12540;&#12479;_&#35299;&#26512;&#65304;_29April2020/DAS28ESR_CDAI_SDAI&#24179;&#22343;&#20516;&#12398;&#25512;&#31227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EULAR%20&#25913;&#21892;&#29575;_HAQ=DI&#35299;&#26512;&#12398;&#12383;&#12417;&#12398;&#12456;&#12463;&#12475;&#12523;&#12487;&#12540;&#12479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SDAI_HAQ_DAS28ESR_CDAI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SDAI_HAQ_DAS28ESR_CDAI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382860532844352"/>
          <c:y val="8.4962181451456495E-2"/>
          <c:w val="0.63814744903462395"/>
          <c:h val="0.658163060273548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DAS28ESR_CDAI_SDAI平均値の推移.xlsx]Sheet3!$C$5</c:f>
              <c:strCache>
                <c:ptCount val="1"/>
                <c:pt idx="0">
                  <c:v>tofacitinib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[DAS28ESR_CDAI_SDAI平均値の推移.xlsx]Sheet3!$D$7:$F$7</c:f>
                <c:numCache>
                  <c:formatCode>General</c:formatCode>
                  <c:ptCount val="3"/>
                  <c:pt idx="0">
                    <c:v>0.3</c:v>
                  </c:pt>
                  <c:pt idx="1">
                    <c:v>0.38</c:v>
                  </c:pt>
                  <c:pt idx="2">
                    <c:v>0.3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DAS28ESR_CDAI_SDAI平均値の推移.xlsx]Sheet3!$D$4:$F$4</c:f>
              <c:strCache>
                <c:ptCount val="3"/>
                <c:pt idx="0">
                  <c:v>4w</c:v>
                </c:pt>
                <c:pt idx="1">
                  <c:v>12w</c:v>
                </c:pt>
                <c:pt idx="2">
                  <c:v>24w</c:v>
                </c:pt>
              </c:strCache>
            </c:strRef>
          </c:cat>
          <c:val>
            <c:numRef>
              <c:f>[DAS28ESR_CDAI_SDAI平均値の推移.xlsx]Sheet3!$D$5:$F$5</c:f>
              <c:numCache>
                <c:formatCode>General</c:formatCode>
                <c:ptCount val="3"/>
                <c:pt idx="0">
                  <c:v>-1.52</c:v>
                </c:pt>
                <c:pt idx="1">
                  <c:v>-1.9</c:v>
                </c:pt>
                <c:pt idx="2">
                  <c:v>-1.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03-40AB-A0E6-A67E28A3FFD0}"/>
            </c:ext>
          </c:extLst>
        </c:ser>
        <c:ser>
          <c:idx val="1"/>
          <c:order val="1"/>
          <c:tx>
            <c:strRef>
              <c:f>[DAS28ESR_CDAI_SDAI平均値の推移.xlsx]Sheet3!$C$6</c:f>
              <c:strCache>
                <c:ptCount val="1"/>
                <c:pt idx="0">
                  <c:v>abatacept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[DAS28ESR_CDAI_SDAI平均値の推移.xlsx]Sheet3!$D$8:$F$8</c:f>
                <c:numCache>
                  <c:formatCode>General</c:formatCode>
                  <c:ptCount val="3"/>
                  <c:pt idx="0">
                    <c:v>0.24</c:v>
                  </c:pt>
                  <c:pt idx="1">
                    <c:v>0.15</c:v>
                  </c:pt>
                  <c:pt idx="2">
                    <c:v>0.3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DAS28ESR_CDAI_SDAI平均値の推移.xlsx]Sheet3!$D$4:$F$4</c:f>
              <c:strCache>
                <c:ptCount val="3"/>
                <c:pt idx="0">
                  <c:v>4w</c:v>
                </c:pt>
                <c:pt idx="1">
                  <c:v>12w</c:v>
                </c:pt>
                <c:pt idx="2">
                  <c:v>24w</c:v>
                </c:pt>
              </c:strCache>
            </c:strRef>
          </c:cat>
          <c:val>
            <c:numRef>
              <c:f>[DAS28ESR_CDAI_SDAI平均値の推移.xlsx]Sheet3!$D$6:$F$6</c:f>
              <c:numCache>
                <c:formatCode>General</c:formatCode>
                <c:ptCount val="3"/>
                <c:pt idx="0">
                  <c:v>-0.83</c:v>
                </c:pt>
                <c:pt idx="1">
                  <c:v>-1.48</c:v>
                </c:pt>
                <c:pt idx="2">
                  <c:v>-1.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503-40AB-A0E6-A67E28A3FF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6385400"/>
        <c:axId val="456403768"/>
      </c:barChart>
      <c:catAx>
        <c:axId val="456385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56403768"/>
        <c:crosses val="autoZero"/>
        <c:auto val="1"/>
        <c:lblAlgn val="ctr"/>
        <c:lblOffset val="100"/>
        <c:noMultiLvlLbl val="0"/>
      </c:catAx>
      <c:valAx>
        <c:axId val="4564037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change from baseline score in DAS28-ES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5638540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472279150037752"/>
          <c:y val="0.8690697345466547"/>
          <c:w val="0.79384208823212166"/>
          <c:h val="9.500212174077042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atacept</a:t>
            </a:r>
          </a:p>
        </c:rich>
      </c:tx>
      <c:layout>
        <c:manualLayout>
          <c:xMode val="edge"/>
          <c:yMode val="edge"/>
          <c:x val="0.31331893077271727"/>
          <c:y val="4.00332734994089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4623837454698938"/>
          <c:y val="0.15898518518518517"/>
          <c:w val="0.40923690453665557"/>
          <c:h val="0.68835311586051739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[EULAR 改善率_HAQ=DI解析のためのエクセルデータ.xlsx]EULAR_TOFABT'!$F$3</c:f>
              <c:strCache>
                <c:ptCount val="1"/>
                <c:pt idx="0">
                  <c:v>good respons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EULAR 改善率_HAQ=DI解析のためのエクセルデータ.xlsx]EULAR_TOFABT'!$G$2:$I$2</c:f>
              <c:numCache>
                <c:formatCode>General</c:formatCode>
                <c:ptCount val="3"/>
                <c:pt idx="0">
                  <c:v>4</c:v>
                </c:pt>
                <c:pt idx="1">
                  <c:v>12</c:v>
                </c:pt>
                <c:pt idx="2">
                  <c:v>24</c:v>
                </c:pt>
              </c:numCache>
            </c:numRef>
          </c:cat>
          <c:val>
            <c:numRef>
              <c:f>'[EULAR 改善率_HAQ=DI解析のためのエクセルデータ.xlsx]EULAR_TOFABT'!$G$3:$I$3</c:f>
              <c:numCache>
                <c:formatCode>General</c:formatCode>
                <c:ptCount val="3"/>
                <c:pt idx="0">
                  <c:v>20</c:v>
                </c:pt>
                <c:pt idx="1">
                  <c:v>38</c:v>
                </c:pt>
                <c:pt idx="2">
                  <c:v>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A8-4B3A-BCBB-7899282A2F47}"/>
            </c:ext>
          </c:extLst>
        </c:ser>
        <c:ser>
          <c:idx val="1"/>
          <c:order val="1"/>
          <c:tx>
            <c:strRef>
              <c:f>'[EULAR 改善率_HAQ=DI解析のためのエクセルデータ.xlsx]EULAR_TOFABT'!$F$4</c:f>
              <c:strCache>
                <c:ptCount val="1"/>
                <c:pt idx="0">
                  <c:v>moderate respons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EULAR 改善率_HAQ=DI解析のためのエクセルデータ.xlsx]EULAR_TOFABT'!$G$2:$I$2</c:f>
              <c:numCache>
                <c:formatCode>General</c:formatCode>
                <c:ptCount val="3"/>
                <c:pt idx="0">
                  <c:v>4</c:v>
                </c:pt>
                <c:pt idx="1">
                  <c:v>12</c:v>
                </c:pt>
                <c:pt idx="2">
                  <c:v>24</c:v>
                </c:pt>
              </c:numCache>
            </c:numRef>
          </c:cat>
          <c:val>
            <c:numRef>
              <c:f>'[EULAR 改善率_HAQ=DI解析のためのエクセルデータ.xlsx]EULAR_TOFABT'!$G$4:$I$4</c:f>
              <c:numCache>
                <c:formatCode>General</c:formatCode>
                <c:ptCount val="3"/>
                <c:pt idx="0">
                  <c:v>30</c:v>
                </c:pt>
                <c:pt idx="1">
                  <c:v>32</c:v>
                </c:pt>
                <c:pt idx="2">
                  <c:v>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A8-4B3A-BCBB-7899282A2F47}"/>
            </c:ext>
          </c:extLst>
        </c:ser>
        <c:ser>
          <c:idx val="2"/>
          <c:order val="2"/>
          <c:tx>
            <c:strRef>
              <c:f>'[EULAR 改善率_HAQ=DI解析のためのエクセルデータ.xlsx]EULAR_TOFABT'!$F$5</c:f>
              <c:strCache>
                <c:ptCount val="1"/>
                <c:pt idx="0">
                  <c:v>no response</c:v>
                </c:pt>
              </c:strCache>
            </c:strRef>
          </c:tx>
          <c:spPr>
            <a:solidFill>
              <a:schemeClr val="accent3">
                <a:tint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EULAR 改善率_HAQ=DI解析のためのエクセルデータ.xlsx]EULAR_TOFABT'!$G$2:$I$2</c:f>
              <c:numCache>
                <c:formatCode>General</c:formatCode>
                <c:ptCount val="3"/>
                <c:pt idx="0">
                  <c:v>4</c:v>
                </c:pt>
                <c:pt idx="1">
                  <c:v>12</c:v>
                </c:pt>
                <c:pt idx="2">
                  <c:v>24</c:v>
                </c:pt>
              </c:numCache>
            </c:numRef>
          </c:cat>
          <c:val>
            <c:numRef>
              <c:f>'[EULAR 改善率_HAQ=DI解析のためのエクセルデータ.xlsx]EULAR_TOFABT'!$G$5:$I$5</c:f>
              <c:numCache>
                <c:formatCode>General</c:formatCode>
                <c:ptCount val="3"/>
                <c:pt idx="0">
                  <c:v>50</c:v>
                </c:pt>
                <c:pt idx="1">
                  <c:v>30</c:v>
                </c:pt>
                <c:pt idx="2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CA8-4B3A-BCBB-7899282A2F47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539448032"/>
        <c:axId val="539451968"/>
      </c:barChart>
      <c:catAx>
        <c:axId val="5394480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9451968"/>
        <c:crosses val="autoZero"/>
        <c:auto val="1"/>
        <c:lblAlgn val="ctr"/>
        <c:lblOffset val="100"/>
        <c:noMultiLvlLbl val="0"/>
      </c:catAx>
      <c:valAx>
        <c:axId val="539451968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ortion</a:t>
                </a:r>
                <a:r>
                  <a:rPr lang="en-US" sz="1200" b="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patients meeting EULAR response crireria</a:t>
                </a:r>
                <a:r>
                  <a:rPr lang="en-US" sz="1200" b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944803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facitinib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8515690597075185"/>
          <c:y val="0.18791717807533087"/>
          <c:w val="0.6624458251899914"/>
          <c:h val="0.60325915623378257"/>
        </c:manualLayout>
      </c:layout>
      <c:lineChart>
        <c:grouping val="standard"/>
        <c:varyColors val="0"/>
        <c:ser>
          <c:idx val="0"/>
          <c:order val="0"/>
          <c:tx>
            <c:strRef>
              <c:f>'[PSマッチング後_SE別解析（各群７０例）.xlsx]Sheet1'!$A$32</c:f>
              <c:strCache>
                <c:ptCount val="1"/>
                <c:pt idx="0">
                  <c:v>SE0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B$35:$E$35</c:f>
                <c:numCache>
                  <c:formatCode>General</c:formatCode>
                  <c:ptCount val="4"/>
                  <c:pt idx="0">
                    <c:v>0.71</c:v>
                  </c:pt>
                  <c:pt idx="1">
                    <c:v>0.54</c:v>
                  </c:pt>
                  <c:pt idx="2">
                    <c:v>0.44</c:v>
                  </c:pt>
                  <c:pt idx="3">
                    <c:v>0.42</c:v>
                  </c:pt>
                </c:numCache>
              </c:numRef>
            </c:plus>
            <c:minus>
              <c:numRef>
                <c:f>'[PSマッチング後_SE別解析（各群７０例）.xlsx]Sheet1'!$B$35:$E$35</c:f>
                <c:numCache>
                  <c:formatCode>General</c:formatCode>
                  <c:ptCount val="4"/>
                  <c:pt idx="0">
                    <c:v>0.71</c:v>
                  </c:pt>
                  <c:pt idx="1">
                    <c:v>0.54</c:v>
                  </c:pt>
                  <c:pt idx="2">
                    <c:v>0.44</c:v>
                  </c:pt>
                  <c:pt idx="3">
                    <c:v>0.42</c:v>
                  </c:pt>
                </c:numCache>
              </c:numRef>
            </c:minus>
            <c:spPr>
              <a:noFill/>
              <a:ln w="19050" cap="flat" cmpd="sng" algn="ctr">
                <a:solidFill>
                  <a:srgbClr val="0070C0"/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B$31:$E$31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B$32:$E$32</c:f>
              <c:numCache>
                <c:formatCode>General</c:formatCode>
                <c:ptCount val="4"/>
                <c:pt idx="0">
                  <c:v>4.5</c:v>
                </c:pt>
                <c:pt idx="1">
                  <c:v>2.7</c:v>
                </c:pt>
                <c:pt idx="2">
                  <c:v>2.5</c:v>
                </c:pt>
                <c:pt idx="3">
                  <c:v>2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320-4DFF-8F3A-C268C930A330}"/>
            </c:ext>
          </c:extLst>
        </c:ser>
        <c:ser>
          <c:idx val="1"/>
          <c:order val="1"/>
          <c:tx>
            <c:strRef>
              <c:f>'[PSマッチング後_SE別解析（各群７０例）.xlsx]Sheet1'!$A$33</c:f>
              <c:strCache>
                <c:ptCount val="1"/>
                <c:pt idx="0">
                  <c:v>SE1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B$36:$E$36</c:f>
                <c:numCache>
                  <c:formatCode>General</c:formatCode>
                  <c:ptCount val="4"/>
                  <c:pt idx="0">
                    <c:v>0.38</c:v>
                  </c:pt>
                  <c:pt idx="1">
                    <c:v>0.36</c:v>
                  </c:pt>
                  <c:pt idx="2">
                    <c:v>0.33</c:v>
                  </c:pt>
                  <c:pt idx="3">
                    <c:v>0.32</c:v>
                  </c:pt>
                </c:numCache>
              </c:numRef>
            </c:plus>
            <c:minus>
              <c:numRef>
                <c:f>'[PSマッチング後_SE別解析（各群７０例）.xlsx]Sheet1'!$B$36:$E$36</c:f>
                <c:numCache>
                  <c:formatCode>General</c:formatCode>
                  <c:ptCount val="4"/>
                  <c:pt idx="0">
                    <c:v>0.38</c:v>
                  </c:pt>
                  <c:pt idx="1">
                    <c:v>0.36</c:v>
                  </c:pt>
                  <c:pt idx="2">
                    <c:v>0.33</c:v>
                  </c:pt>
                  <c:pt idx="3">
                    <c:v>0.3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accent2"/>
                </a:solidFill>
                <a:prstDash val="solid"/>
                <a:miter lim="800000"/>
              </a:ln>
              <a:effectLst/>
            </c:spPr>
          </c:errBars>
          <c:cat>
            <c:strRef>
              <c:f>'[PSマッチング後_SE別解析（各群７０例）.xlsx]Sheet1'!$B$31:$E$31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B$33:$E$33</c:f>
              <c:numCache>
                <c:formatCode>General</c:formatCode>
                <c:ptCount val="4"/>
                <c:pt idx="0">
                  <c:v>4.9000000000000004</c:v>
                </c:pt>
                <c:pt idx="1">
                  <c:v>3.6</c:v>
                </c:pt>
                <c:pt idx="2">
                  <c:v>3</c:v>
                </c:pt>
                <c:pt idx="3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320-4DFF-8F3A-C268C930A330}"/>
            </c:ext>
          </c:extLst>
        </c:ser>
        <c:ser>
          <c:idx val="2"/>
          <c:order val="2"/>
          <c:tx>
            <c:strRef>
              <c:f>'[PSマッチング後_SE別解析（各群７０例）.xlsx]Sheet1'!$A$34</c:f>
              <c:strCache>
                <c:ptCount val="1"/>
                <c:pt idx="0">
                  <c:v>SE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B$37:$E$37</c:f>
                <c:numCache>
                  <c:formatCode>General</c:formatCode>
                  <c:ptCount val="4"/>
                  <c:pt idx="0">
                    <c:v>1.1000000000000001</c:v>
                  </c:pt>
                  <c:pt idx="1">
                    <c:v>0.99</c:v>
                  </c:pt>
                  <c:pt idx="2">
                    <c:v>1</c:v>
                  </c:pt>
                  <c:pt idx="3">
                    <c:v>0.79</c:v>
                  </c:pt>
                </c:numCache>
              </c:numRef>
            </c:plus>
            <c:minus>
              <c:numRef>
                <c:f>'[PSマッチング後_SE別解析（各群７０例）.xlsx]Sheet1'!$B$37:$E$37</c:f>
                <c:numCache>
                  <c:formatCode>General</c:formatCode>
                  <c:ptCount val="4"/>
                  <c:pt idx="0">
                    <c:v>1.1000000000000001</c:v>
                  </c:pt>
                  <c:pt idx="1">
                    <c:v>0.99</c:v>
                  </c:pt>
                  <c:pt idx="2">
                    <c:v>1</c:v>
                  </c:pt>
                  <c:pt idx="3">
                    <c:v>0.7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bg1">
                    <a:lumMod val="65000"/>
                  </a:schemeClr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B$31:$E$31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B$34:$E$34</c:f>
              <c:numCache>
                <c:formatCode>General</c:formatCode>
                <c:ptCount val="4"/>
                <c:pt idx="0">
                  <c:v>4.8</c:v>
                </c:pt>
                <c:pt idx="1">
                  <c:v>3</c:v>
                </c:pt>
                <c:pt idx="2">
                  <c:v>2.2999999999999998</c:v>
                </c:pt>
                <c:pt idx="3">
                  <c:v>2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320-4DFF-8F3A-C268C930A3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8602736"/>
        <c:axId val="438603392"/>
      </c:lineChart>
      <c:catAx>
        <c:axId val="438602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603392"/>
        <c:crosses val="autoZero"/>
        <c:auto val="1"/>
        <c:lblAlgn val="ctr"/>
        <c:lblOffset val="100"/>
        <c:noMultiLvlLbl val="0"/>
      </c:catAx>
      <c:valAx>
        <c:axId val="438603392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</a:t>
                </a:r>
                <a:r>
                  <a:rPr lang="en-US" altLang="ja-JP" sz="12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AS28-ESR</a:t>
                </a:r>
                <a:endParaRPr lang="ja-JP" alt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2706762718489976E-2"/>
              <c:y val="0.181500437445319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602736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facitinib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0807982761745578"/>
          <c:y val="0.18246392896781355"/>
          <c:w val="0.75345872686630277"/>
          <c:h val="0.58003723893487669"/>
        </c:manualLayout>
      </c:layout>
      <c:lineChart>
        <c:grouping val="standard"/>
        <c:varyColors val="0"/>
        <c:ser>
          <c:idx val="0"/>
          <c:order val="0"/>
          <c:tx>
            <c:strRef>
              <c:f>'[PSマッチング後_SE別解析（各群７０例）.xlsx]Sheet1'!$A$23</c:f>
              <c:strCache>
                <c:ptCount val="1"/>
                <c:pt idx="0">
                  <c:v>SE0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B$26:$E$26</c:f>
                <c:numCache>
                  <c:formatCode>General</c:formatCode>
                  <c:ptCount val="4"/>
                  <c:pt idx="0">
                    <c:v>5.4</c:v>
                  </c:pt>
                  <c:pt idx="1">
                    <c:v>3</c:v>
                  </c:pt>
                  <c:pt idx="2">
                    <c:v>2.8</c:v>
                  </c:pt>
                  <c:pt idx="3">
                    <c:v>2.2000000000000002</c:v>
                  </c:pt>
                </c:numCache>
              </c:numRef>
            </c:plus>
            <c:minus>
              <c:numRef>
                <c:f>'[PSマッチング後_SE別解析（各群７０例）.xlsx]Sheet1'!$B$26:$E$26</c:f>
                <c:numCache>
                  <c:formatCode>General</c:formatCode>
                  <c:ptCount val="4"/>
                  <c:pt idx="0">
                    <c:v>5.4</c:v>
                  </c:pt>
                  <c:pt idx="1">
                    <c:v>3</c:v>
                  </c:pt>
                  <c:pt idx="2">
                    <c:v>2.8</c:v>
                  </c:pt>
                  <c:pt idx="3">
                    <c:v>2.2000000000000002</c:v>
                  </c:pt>
                </c:numCache>
              </c:numRef>
            </c:minus>
            <c:spPr>
              <a:noFill/>
              <a:ln w="19050" cap="flat" cmpd="sng" algn="ctr">
                <a:solidFill>
                  <a:srgbClr val="0070C0"/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B$22:$E$22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B$23:$E$23</c:f>
              <c:numCache>
                <c:formatCode>General</c:formatCode>
                <c:ptCount val="4"/>
                <c:pt idx="0">
                  <c:v>20.2</c:v>
                </c:pt>
                <c:pt idx="1">
                  <c:v>7.1</c:v>
                </c:pt>
                <c:pt idx="2">
                  <c:v>6</c:v>
                </c:pt>
                <c:pt idx="3">
                  <c:v>5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E5A-4154-B635-20BA4F496EEF}"/>
            </c:ext>
          </c:extLst>
        </c:ser>
        <c:ser>
          <c:idx val="1"/>
          <c:order val="1"/>
          <c:tx>
            <c:strRef>
              <c:f>'[PSマッチング後_SE別解析（各群７０例）.xlsx]Sheet1'!$A$24</c:f>
              <c:strCache>
                <c:ptCount val="1"/>
                <c:pt idx="0">
                  <c:v>SE1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B$27:$E$27</c:f>
                <c:numCache>
                  <c:formatCode>General</c:formatCode>
                  <c:ptCount val="4"/>
                  <c:pt idx="0">
                    <c:v>3.2</c:v>
                  </c:pt>
                  <c:pt idx="1">
                    <c:v>1.9</c:v>
                  </c:pt>
                  <c:pt idx="2">
                    <c:v>2.2000000000000002</c:v>
                  </c:pt>
                  <c:pt idx="3">
                    <c:v>1.7</c:v>
                  </c:pt>
                </c:numCache>
              </c:numRef>
            </c:plus>
            <c:minus>
              <c:numRef>
                <c:f>'[PSマッチング後_SE別解析（各群７０例）.xlsx]Sheet1'!$B$27:$E$27</c:f>
                <c:numCache>
                  <c:formatCode>General</c:formatCode>
                  <c:ptCount val="4"/>
                  <c:pt idx="0">
                    <c:v>3.2</c:v>
                  </c:pt>
                  <c:pt idx="1">
                    <c:v>1.9</c:v>
                  </c:pt>
                  <c:pt idx="2">
                    <c:v>2.2000000000000002</c:v>
                  </c:pt>
                  <c:pt idx="3">
                    <c:v>1.7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accent2"/>
                </a:solidFill>
                <a:prstDash val="solid"/>
                <a:miter lim="800000"/>
              </a:ln>
              <a:effectLst/>
            </c:spPr>
          </c:errBars>
          <c:cat>
            <c:strRef>
              <c:f>'[PSマッチング後_SE別解析（各群７０例）.xlsx]Sheet1'!$B$22:$E$22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B$24:$E$24</c:f>
              <c:numCache>
                <c:formatCode>General</c:formatCode>
                <c:ptCount val="4"/>
                <c:pt idx="0">
                  <c:v>20.5</c:v>
                </c:pt>
                <c:pt idx="1">
                  <c:v>9.5</c:v>
                </c:pt>
                <c:pt idx="2">
                  <c:v>6.7</c:v>
                </c:pt>
                <c:pt idx="3">
                  <c:v>6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E5A-4154-B635-20BA4F496EEF}"/>
            </c:ext>
          </c:extLst>
        </c:ser>
        <c:ser>
          <c:idx val="2"/>
          <c:order val="2"/>
          <c:tx>
            <c:strRef>
              <c:f>'[PSマッチング後_SE別解析（各群７０例）.xlsx]Sheet1'!$A$25</c:f>
              <c:strCache>
                <c:ptCount val="1"/>
                <c:pt idx="0">
                  <c:v>SE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B$28:$E$28</c:f>
                <c:numCache>
                  <c:formatCode>General</c:formatCode>
                  <c:ptCount val="4"/>
                  <c:pt idx="0">
                    <c:v>6.9</c:v>
                  </c:pt>
                  <c:pt idx="1">
                    <c:v>3.3</c:v>
                  </c:pt>
                  <c:pt idx="2">
                    <c:v>3.5</c:v>
                  </c:pt>
                  <c:pt idx="3">
                    <c:v>2.9</c:v>
                  </c:pt>
                </c:numCache>
              </c:numRef>
            </c:plus>
            <c:minus>
              <c:numRef>
                <c:f>'[PSマッチング後_SE別解析（各群７０例）.xlsx]Sheet1'!$B$28:$E$28</c:f>
                <c:numCache>
                  <c:formatCode>General</c:formatCode>
                  <c:ptCount val="4"/>
                  <c:pt idx="0">
                    <c:v>6.9</c:v>
                  </c:pt>
                  <c:pt idx="1">
                    <c:v>3.3</c:v>
                  </c:pt>
                  <c:pt idx="2">
                    <c:v>3.5</c:v>
                  </c:pt>
                  <c:pt idx="3">
                    <c:v>2.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bg1">
                    <a:lumMod val="65000"/>
                  </a:schemeClr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B$22:$E$22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B$25:$E$25</c:f>
              <c:numCache>
                <c:formatCode>General</c:formatCode>
                <c:ptCount val="4"/>
                <c:pt idx="0">
                  <c:v>19.3</c:v>
                </c:pt>
                <c:pt idx="1">
                  <c:v>6.2</c:v>
                </c:pt>
                <c:pt idx="2">
                  <c:v>4.7</c:v>
                </c:pt>
                <c:pt idx="3">
                  <c:v>5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E5A-4154-B635-20BA4F496E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4499672"/>
        <c:axId val="504501640"/>
      </c:lineChart>
      <c:catAx>
        <c:axId val="504499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4501640"/>
        <c:crosses val="autoZero"/>
        <c:auto val="1"/>
        <c:lblAlgn val="ctr"/>
        <c:lblOffset val="100"/>
        <c:noMultiLvlLbl val="0"/>
      </c:catAx>
      <c:valAx>
        <c:axId val="504501640"/>
        <c:scaling>
          <c:orientation val="minMax"/>
          <c:max val="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CDA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4499672"/>
        <c:crosses val="autoZero"/>
        <c:crossBetween val="between"/>
        <c:majorUnit val="10"/>
      </c:valAx>
      <c:spPr>
        <a:noFill/>
        <a:ln w="12700"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12700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facitinib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8640672285721432"/>
          <c:y val="0.16666979540089477"/>
          <c:w val="0.70277582258174009"/>
          <c:h val="0.62743923198831242"/>
        </c:manualLayout>
      </c:layout>
      <c:lineChart>
        <c:grouping val="standard"/>
        <c:varyColors val="0"/>
        <c:ser>
          <c:idx val="0"/>
          <c:order val="0"/>
          <c:tx>
            <c:strRef>
              <c:f>'[PSマッチング後_SE別解析（各群７０例）.xlsx]Sheet1'!$A$4</c:f>
              <c:strCache>
                <c:ptCount val="1"/>
                <c:pt idx="0">
                  <c:v>SE0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B$7:$E$7</c:f>
                <c:numCache>
                  <c:formatCode>General</c:formatCode>
                  <c:ptCount val="4"/>
                  <c:pt idx="0">
                    <c:v>5.9</c:v>
                  </c:pt>
                  <c:pt idx="1">
                    <c:v>3</c:v>
                  </c:pt>
                  <c:pt idx="2">
                    <c:v>2.8</c:v>
                  </c:pt>
                  <c:pt idx="3">
                    <c:v>2.2000000000000002</c:v>
                  </c:pt>
                </c:numCache>
              </c:numRef>
            </c:plus>
            <c:minus>
              <c:numRef>
                <c:f>'[PSマッチング後_SE別解析（各群７０例）.xlsx]Sheet1'!$B$7:$E$7</c:f>
                <c:numCache>
                  <c:formatCode>General</c:formatCode>
                  <c:ptCount val="4"/>
                  <c:pt idx="0">
                    <c:v>5.9</c:v>
                  </c:pt>
                  <c:pt idx="1">
                    <c:v>3</c:v>
                  </c:pt>
                  <c:pt idx="2">
                    <c:v>2.8</c:v>
                  </c:pt>
                  <c:pt idx="3">
                    <c:v>2.200000000000000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accent1"/>
                </a:solidFill>
                <a:prstDash val="solid"/>
                <a:miter lim="800000"/>
              </a:ln>
              <a:effectLst/>
            </c:spPr>
          </c:errBars>
          <c:cat>
            <c:strRef>
              <c:f>'[PSマッチング後_SE別解析（各群７０例）.xlsx]Sheet1'!$B$3:$E$3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B$4:$E$4</c:f>
              <c:numCache>
                <c:formatCode>General</c:formatCode>
                <c:ptCount val="4"/>
                <c:pt idx="0">
                  <c:v>21.213999999999999</c:v>
                </c:pt>
                <c:pt idx="1">
                  <c:v>7.92</c:v>
                </c:pt>
                <c:pt idx="2">
                  <c:v>6.2530000000000001</c:v>
                </c:pt>
                <c:pt idx="3">
                  <c:v>6.004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83B-4A3E-92D1-C2F79934B378}"/>
            </c:ext>
          </c:extLst>
        </c:ser>
        <c:ser>
          <c:idx val="1"/>
          <c:order val="1"/>
          <c:tx>
            <c:strRef>
              <c:f>'[PSマッチング後_SE別解析（各群７０例）.xlsx]Sheet1'!$A$5</c:f>
              <c:strCache>
                <c:ptCount val="1"/>
                <c:pt idx="0">
                  <c:v>SE1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B$8:$E$8</c:f>
                <c:numCache>
                  <c:formatCode>General</c:formatCode>
                  <c:ptCount val="4"/>
                  <c:pt idx="0">
                    <c:v>3.5</c:v>
                  </c:pt>
                  <c:pt idx="1">
                    <c:v>2.1</c:v>
                  </c:pt>
                  <c:pt idx="2">
                    <c:v>2.2000000000000002</c:v>
                  </c:pt>
                  <c:pt idx="3">
                    <c:v>1.8</c:v>
                  </c:pt>
                </c:numCache>
              </c:numRef>
            </c:plus>
            <c:minus>
              <c:numRef>
                <c:f>'[PSマッチング後_SE別解析（各群７０例）.xlsx]Sheet1'!$B$8:$E$8</c:f>
                <c:numCache>
                  <c:formatCode>General</c:formatCode>
                  <c:ptCount val="4"/>
                  <c:pt idx="0">
                    <c:v>3.5</c:v>
                  </c:pt>
                  <c:pt idx="1">
                    <c:v>2.1</c:v>
                  </c:pt>
                  <c:pt idx="2">
                    <c:v>2.2000000000000002</c:v>
                  </c:pt>
                  <c:pt idx="3">
                    <c:v>1.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accent2"/>
                </a:solidFill>
                <a:prstDash val="solid"/>
                <a:miter lim="800000"/>
              </a:ln>
              <a:effectLst/>
            </c:spPr>
          </c:errBars>
          <c:cat>
            <c:strRef>
              <c:f>'[PSマッチング後_SE別解析（各群７０例）.xlsx]Sheet1'!$B$3:$E$3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B$5:$E$5</c:f>
              <c:numCache>
                <c:formatCode>General</c:formatCode>
                <c:ptCount val="4"/>
                <c:pt idx="0">
                  <c:v>22.11</c:v>
                </c:pt>
                <c:pt idx="1">
                  <c:v>10.007999999999999</c:v>
                </c:pt>
                <c:pt idx="2">
                  <c:v>7.1749999999999998</c:v>
                </c:pt>
                <c:pt idx="3">
                  <c:v>6.894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83B-4A3E-92D1-C2F79934B378}"/>
            </c:ext>
          </c:extLst>
        </c:ser>
        <c:ser>
          <c:idx val="2"/>
          <c:order val="2"/>
          <c:tx>
            <c:strRef>
              <c:f>'[PSマッチング後_SE別解析（各群７０例）.xlsx]Sheet1'!$A$6</c:f>
              <c:strCache>
                <c:ptCount val="1"/>
                <c:pt idx="0">
                  <c:v>SE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B$9:$E$9</c:f>
                <c:numCache>
                  <c:formatCode>General</c:formatCode>
                  <c:ptCount val="4"/>
                  <c:pt idx="0">
                    <c:v>6.6</c:v>
                  </c:pt>
                  <c:pt idx="1">
                    <c:v>3.8</c:v>
                  </c:pt>
                  <c:pt idx="2">
                    <c:v>3.7</c:v>
                  </c:pt>
                  <c:pt idx="3">
                    <c:v>3.5</c:v>
                  </c:pt>
                </c:numCache>
              </c:numRef>
            </c:plus>
            <c:minus>
              <c:numRef>
                <c:f>'[PSマッチング後_SE別解析（各群７０例）.xlsx]Sheet1'!$B$9:$E$9</c:f>
                <c:numCache>
                  <c:formatCode>General</c:formatCode>
                  <c:ptCount val="4"/>
                  <c:pt idx="0">
                    <c:v>6.6</c:v>
                  </c:pt>
                  <c:pt idx="1">
                    <c:v>3.8</c:v>
                  </c:pt>
                  <c:pt idx="2">
                    <c:v>3.7</c:v>
                  </c:pt>
                  <c:pt idx="3">
                    <c:v>3.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bg1">
                    <a:lumMod val="65000"/>
                  </a:schemeClr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B$3:$E$3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B$6:$E$6</c:f>
              <c:numCache>
                <c:formatCode>General</c:formatCode>
                <c:ptCount val="4"/>
                <c:pt idx="0">
                  <c:v>23.2</c:v>
                </c:pt>
                <c:pt idx="1">
                  <c:v>6.76</c:v>
                </c:pt>
                <c:pt idx="2">
                  <c:v>4.9420000000000002</c:v>
                </c:pt>
                <c:pt idx="3">
                  <c:v>6.322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83B-4A3E-92D1-C2F79934B3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5657584"/>
        <c:axId val="575653976"/>
      </c:lineChart>
      <c:catAx>
        <c:axId val="575657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653976"/>
        <c:crosses val="autoZero"/>
        <c:auto val="1"/>
        <c:lblAlgn val="ctr"/>
        <c:lblOffset val="100"/>
        <c:noMultiLvlLbl val="0"/>
      </c:catAx>
      <c:valAx>
        <c:axId val="575653976"/>
        <c:scaling>
          <c:orientation val="minMax"/>
          <c:max val="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SDA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565758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atacep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7992119310297747"/>
          <c:y val="0.17390498436499266"/>
          <c:w val="0.6942596915071263"/>
          <c:h val="0.62566309419655874"/>
        </c:manualLayout>
      </c:layout>
      <c:lineChart>
        <c:grouping val="standard"/>
        <c:varyColors val="0"/>
        <c:ser>
          <c:idx val="0"/>
          <c:order val="0"/>
          <c:tx>
            <c:strRef>
              <c:f>'[PSマッチング後_SE別解析（各群７０例）.xlsx]Sheet1'!$G$32</c:f>
              <c:strCache>
                <c:ptCount val="1"/>
                <c:pt idx="0">
                  <c:v>SE0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H$35:$K$35</c:f>
                <c:numCache>
                  <c:formatCode>General</c:formatCode>
                  <c:ptCount val="4"/>
                  <c:pt idx="0">
                    <c:v>0.53</c:v>
                  </c:pt>
                  <c:pt idx="1">
                    <c:v>0.56000000000000005</c:v>
                  </c:pt>
                  <c:pt idx="2">
                    <c:v>0.33</c:v>
                  </c:pt>
                  <c:pt idx="3">
                    <c:v>0.27</c:v>
                  </c:pt>
                </c:numCache>
              </c:numRef>
            </c:plus>
            <c:minus>
              <c:numRef>
                <c:f>'[PSマッチング後_SE別解析（各群７０例）.xlsx]Sheet1'!$H$35:$K$35</c:f>
                <c:numCache>
                  <c:formatCode>General</c:formatCode>
                  <c:ptCount val="4"/>
                  <c:pt idx="0">
                    <c:v>0.53</c:v>
                  </c:pt>
                  <c:pt idx="1">
                    <c:v>0.56000000000000005</c:v>
                  </c:pt>
                  <c:pt idx="2">
                    <c:v>0.33</c:v>
                  </c:pt>
                  <c:pt idx="3">
                    <c:v>0.27</c:v>
                  </c:pt>
                </c:numCache>
              </c:numRef>
            </c:minus>
            <c:spPr>
              <a:noFill/>
              <a:ln w="19050" cap="flat" cmpd="sng" algn="ctr">
                <a:solidFill>
                  <a:srgbClr val="0070C0"/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H$31:$K$31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H$32:$K$32</c:f>
              <c:numCache>
                <c:formatCode>General</c:formatCode>
                <c:ptCount val="4"/>
                <c:pt idx="0">
                  <c:v>4.7</c:v>
                </c:pt>
                <c:pt idx="1">
                  <c:v>4.0999999999999996</c:v>
                </c:pt>
                <c:pt idx="2">
                  <c:v>3.6</c:v>
                </c:pt>
                <c:pt idx="3">
                  <c:v>3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C48-4149-81DC-46BD56EC32B7}"/>
            </c:ext>
          </c:extLst>
        </c:ser>
        <c:ser>
          <c:idx val="1"/>
          <c:order val="1"/>
          <c:tx>
            <c:strRef>
              <c:f>'[PSマッチング後_SE別解析（各群７０例）.xlsx]Sheet1'!$G$33</c:f>
              <c:strCache>
                <c:ptCount val="1"/>
                <c:pt idx="0">
                  <c:v>SE1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H$36:$K$36</c:f>
                <c:numCache>
                  <c:formatCode>General</c:formatCode>
                  <c:ptCount val="4"/>
                  <c:pt idx="0">
                    <c:v>0.41</c:v>
                  </c:pt>
                  <c:pt idx="1">
                    <c:v>0.44</c:v>
                  </c:pt>
                  <c:pt idx="2">
                    <c:v>0.36</c:v>
                  </c:pt>
                  <c:pt idx="3">
                    <c:v>0.34</c:v>
                  </c:pt>
                </c:numCache>
              </c:numRef>
            </c:plus>
            <c:minus>
              <c:numRef>
                <c:f>'[PSマッチング後_SE別解析（各群７０例）.xlsx]Sheet1'!$H$36:$K$36</c:f>
                <c:numCache>
                  <c:formatCode>General</c:formatCode>
                  <c:ptCount val="4"/>
                  <c:pt idx="0">
                    <c:v>0.41</c:v>
                  </c:pt>
                  <c:pt idx="1">
                    <c:v>0.44</c:v>
                  </c:pt>
                  <c:pt idx="2">
                    <c:v>0.36</c:v>
                  </c:pt>
                  <c:pt idx="3">
                    <c:v>0.34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accent2"/>
                </a:solidFill>
                <a:prstDash val="solid"/>
                <a:miter lim="800000"/>
              </a:ln>
              <a:effectLst/>
            </c:spPr>
          </c:errBars>
          <c:cat>
            <c:strRef>
              <c:f>'[PSマッチング後_SE別解析（各群７０例）.xlsx]Sheet1'!$H$31:$K$31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H$33:$K$33</c:f>
              <c:numCache>
                <c:formatCode>General</c:formatCode>
                <c:ptCount val="4"/>
                <c:pt idx="0">
                  <c:v>4.8</c:v>
                </c:pt>
                <c:pt idx="1">
                  <c:v>4</c:v>
                </c:pt>
                <c:pt idx="2">
                  <c:v>3.2</c:v>
                </c:pt>
                <c:pt idx="3">
                  <c:v>2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C48-4149-81DC-46BD56EC32B7}"/>
            </c:ext>
          </c:extLst>
        </c:ser>
        <c:ser>
          <c:idx val="2"/>
          <c:order val="2"/>
          <c:tx>
            <c:strRef>
              <c:f>'[PSマッチング後_SE別解析（各群７０例）.xlsx]Sheet1'!$G$34</c:f>
              <c:strCache>
                <c:ptCount val="1"/>
                <c:pt idx="0">
                  <c:v>SE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H$37:$K$37</c:f>
                <c:numCache>
                  <c:formatCode>General</c:formatCode>
                  <c:ptCount val="4"/>
                  <c:pt idx="0">
                    <c:v>0.67</c:v>
                  </c:pt>
                  <c:pt idx="1">
                    <c:v>0.68</c:v>
                  </c:pt>
                  <c:pt idx="2">
                    <c:v>0.73</c:v>
                  </c:pt>
                  <c:pt idx="3">
                    <c:v>0.69</c:v>
                  </c:pt>
                </c:numCache>
              </c:numRef>
            </c:plus>
            <c:minus>
              <c:numRef>
                <c:f>'[PSマッチング後_SE別解析（各群７０例）.xlsx]Sheet1'!$H$37:$K$37</c:f>
                <c:numCache>
                  <c:formatCode>General</c:formatCode>
                  <c:ptCount val="4"/>
                  <c:pt idx="0">
                    <c:v>0.67</c:v>
                  </c:pt>
                  <c:pt idx="1">
                    <c:v>0.68</c:v>
                  </c:pt>
                  <c:pt idx="2">
                    <c:v>0.73</c:v>
                  </c:pt>
                  <c:pt idx="3">
                    <c:v>0.6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bg1">
                    <a:lumMod val="65000"/>
                  </a:schemeClr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H$31:$K$31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H$34:$K$34</c:f>
              <c:numCache>
                <c:formatCode>General</c:formatCode>
                <c:ptCount val="4"/>
                <c:pt idx="0">
                  <c:v>4.5</c:v>
                </c:pt>
                <c:pt idx="1">
                  <c:v>2.9</c:v>
                </c:pt>
                <c:pt idx="2">
                  <c:v>2.6</c:v>
                </c:pt>
                <c:pt idx="3">
                  <c:v>2.29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C48-4149-81DC-46BD56EC32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8549688"/>
        <c:axId val="508550672"/>
      </c:lineChart>
      <c:catAx>
        <c:axId val="508549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8550672"/>
        <c:crosses val="autoZero"/>
        <c:auto val="1"/>
        <c:lblAlgn val="ctr"/>
        <c:lblOffset val="100"/>
        <c:noMultiLvlLbl val="0"/>
      </c:catAx>
      <c:valAx>
        <c:axId val="508550672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DAS28-ESR</a:t>
                </a:r>
              </a:p>
            </c:rich>
          </c:tx>
          <c:layout>
            <c:manualLayout>
              <c:xMode val="edge"/>
              <c:yMode val="edge"/>
              <c:x val="1.831673863347727E-2"/>
              <c:y val="0.195129248669813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854968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atacep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0471885441741478"/>
          <c:y val="0.18538316005693797"/>
          <c:w val="0.69872219801670898"/>
          <c:h val="0.59369552210229037"/>
        </c:manualLayout>
      </c:layout>
      <c:lineChart>
        <c:grouping val="standard"/>
        <c:varyColors val="0"/>
        <c:ser>
          <c:idx val="0"/>
          <c:order val="0"/>
          <c:tx>
            <c:strRef>
              <c:f>'[PSマッチング後_SE別解析（各群７０例）.xlsx]Sheet1'!$G$23</c:f>
              <c:strCache>
                <c:ptCount val="1"/>
                <c:pt idx="0">
                  <c:v>SE0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H$26:$K$26</c:f>
                <c:numCache>
                  <c:formatCode>General</c:formatCode>
                  <c:ptCount val="4"/>
                  <c:pt idx="0">
                    <c:v>4.3</c:v>
                  </c:pt>
                  <c:pt idx="1">
                    <c:v>3.5</c:v>
                  </c:pt>
                  <c:pt idx="2">
                    <c:v>1.4</c:v>
                  </c:pt>
                  <c:pt idx="3">
                    <c:v>2.1</c:v>
                  </c:pt>
                </c:numCache>
              </c:numRef>
            </c:plus>
            <c:minus>
              <c:numRef>
                <c:f>'[PSマッチング後_SE別解析（各群７０例）.xlsx]Sheet1'!$H$26:$K$26</c:f>
                <c:numCache>
                  <c:formatCode>General</c:formatCode>
                  <c:ptCount val="4"/>
                  <c:pt idx="0">
                    <c:v>4.3</c:v>
                  </c:pt>
                  <c:pt idx="1">
                    <c:v>3.5</c:v>
                  </c:pt>
                  <c:pt idx="2">
                    <c:v>1.4</c:v>
                  </c:pt>
                  <c:pt idx="3">
                    <c:v>2.1</c:v>
                  </c:pt>
                </c:numCache>
              </c:numRef>
            </c:minus>
            <c:spPr>
              <a:noFill/>
              <a:ln w="19050" cap="flat" cmpd="sng" algn="ctr">
                <a:solidFill>
                  <a:srgbClr val="0070C0"/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H$22:$K$22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H$23:$K$23</c:f>
              <c:numCache>
                <c:formatCode>General</c:formatCode>
                <c:ptCount val="4"/>
                <c:pt idx="0">
                  <c:v>19.2</c:v>
                </c:pt>
                <c:pt idx="1">
                  <c:v>14.1</c:v>
                </c:pt>
                <c:pt idx="2">
                  <c:v>9.4</c:v>
                </c:pt>
                <c:pt idx="3">
                  <c:v>8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858-4793-85BC-2C34C6623162}"/>
            </c:ext>
          </c:extLst>
        </c:ser>
        <c:ser>
          <c:idx val="1"/>
          <c:order val="1"/>
          <c:tx>
            <c:strRef>
              <c:f>'[PSマッチング後_SE別解析（各群７０例）.xlsx]Sheet1'!$G$24</c:f>
              <c:strCache>
                <c:ptCount val="1"/>
                <c:pt idx="0">
                  <c:v>SE1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H$27:$K$27</c:f>
                <c:numCache>
                  <c:formatCode>General</c:formatCode>
                  <c:ptCount val="4"/>
                  <c:pt idx="0">
                    <c:v>3.5</c:v>
                  </c:pt>
                  <c:pt idx="1">
                    <c:v>2.7</c:v>
                  </c:pt>
                  <c:pt idx="2">
                    <c:v>1.9</c:v>
                  </c:pt>
                  <c:pt idx="3">
                    <c:v>1.6</c:v>
                  </c:pt>
                </c:numCache>
              </c:numRef>
            </c:plus>
            <c:minus>
              <c:numRef>
                <c:f>'[PSマッチング後_SE別解析（各群７０例）.xlsx]Sheet1'!$H$27:$K$27</c:f>
                <c:numCache>
                  <c:formatCode>General</c:formatCode>
                  <c:ptCount val="4"/>
                  <c:pt idx="0">
                    <c:v>3.5</c:v>
                  </c:pt>
                  <c:pt idx="1">
                    <c:v>2.7</c:v>
                  </c:pt>
                  <c:pt idx="2">
                    <c:v>1.9</c:v>
                  </c:pt>
                  <c:pt idx="3">
                    <c:v>1.6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accent2"/>
                </a:solidFill>
                <a:prstDash val="solid"/>
                <a:miter lim="800000"/>
              </a:ln>
              <a:effectLst/>
            </c:spPr>
          </c:errBars>
          <c:cat>
            <c:strRef>
              <c:f>'[PSマッチング後_SE別解析（各群７０例）.xlsx]Sheet1'!$H$22:$K$22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H$24:$K$24</c:f>
              <c:numCache>
                <c:formatCode>General</c:formatCode>
                <c:ptCount val="4"/>
                <c:pt idx="0">
                  <c:v>19.7</c:v>
                </c:pt>
                <c:pt idx="1">
                  <c:v>12.7</c:v>
                </c:pt>
                <c:pt idx="2">
                  <c:v>8</c:v>
                </c:pt>
                <c:pt idx="3">
                  <c:v>6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858-4793-85BC-2C34C6623162}"/>
            </c:ext>
          </c:extLst>
        </c:ser>
        <c:ser>
          <c:idx val="2"/>
          <c:order val="2"/>
          <c:tx>
            <c:strRef>
              <c:f>'[PSマッチング後_SE別解析（各群７０例）.xlsx]Sheet1'!$G$25</c:f>
              <c:strCache>
                <c:ptCount val="1"/>
                <c:pt idx="0">
                  <c:v>SE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H$28:$K$28</c:f>
                <c:numCache>
                  <c:formatCode>General</c:formatCode>
                  <c:ptCount val="4"/>
                  <c:pt idx="0">
                    <c:v>4.5999999999999996</c:v>
                  </c:pt>
                  <c:pt idx="1">
                    <c:v>1.7</c:v>
                  </c:pt>
                  <c:pt idx="2">
                    <c:v>2.7</c:v>
                  </c:pt>
                  <c:pt idx="3">
                    <c:v>2.2999999999999998</c:v>
                  </c:pt>
                </c:numCache>
              </c:numRef>
            </c:plus>
            <c:minus>
              <c:numRef>
                <c:f>'[PSマッチング後_SE別解析（各群７０例）.xlsx]Sheet1'!$H$28:$K$28</c:f>
                <c:numCache>
                  <c:formatCode>General</c:formatCode>
                  <c:ptCount val="4"/>
                  <c:pt idx="0">
                    <c:v>4.5999999999999996</c:v>
                  </c:pt>
                  <c:pt idx="1">
                    <c:v>1.7</c:v>
                  </c:pt>
                  <c:pt idx="2">
                    <c:v>2.7</c:v>
                  </c:pt>
                  <c:pt idx="3">
                    <c:v>2.299999999999999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bg1">
                    <a:lumMod val="65000"/>
                  </a:schemeClr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H$22:$K$22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H$25:$K$25</c:f>
              <c:numCache>
                <c:formatCode>General</c:formatCode>
                <c:ptCount val="4"/>
                <c:pt idx="0">
                  <c:v>17.5</c:v>
                </c:pt>
                <c:pt idx="1">
                  <c:v>7.2</c:v>
                </c:pt>
                <c:pt idx="2">
                  <c:v>5.6</c:v>
                </c:pt>
                <c:pt idx="3">
                  <c:v>4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858-4793-85BC-2C34C66231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8543456"/>
        <c:axId val="508545096"/>
      </c:lineChart>
      <c:catAx>
        <c:axId val="508543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8545096"/>
        <c:crosses val="autoZero"/>
        <c:auto val="1"/>
        <c:lblAlgn val="ctr"/>
        <c:lblOffset val="100"/>
        <c:noMultiLvlLbl val="0"/>
      </c:catAx>
      <c:valAx>
        <c:axId val="508545096"/>
        <c:scaling>
          <c:orientation val="minMax"/>
          <c:max val="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CDA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854345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12700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atacept</a:t>
            </a:r>
            <a:endParaRPr lang="ja-JP" altLang="en-US" b="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9578305628702466"/>
          <c:y val="0.17090361988504296"/>
          <c:w val="0.734435561132874"/>
          <c:h val="0.6663449586245489"/>
        </c:manualLayout>
      </c:layout>
      <c:lineChart>
        <c:grouping val="standard"/>
        <c:varyColors val="0"/>
        <c:ser>
          <c:idx val="0"/>
          <c:order val="0"/>
          <c:tx>
            <c:strRef>
              <c:f>'[PSマッチング後_SE別解析（各群７０例）.xlsx]Sheet1'!$G$4</c:f>
              <c:strCache>
                <c:ptCount val="1"/>
                <c:pt idx="0">
                  <c:v>SE0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H$7:$K$7</c:f>
                <c:numCache>
                  <c:formatCode>General</c:formatCode>
                  <c:ptCount val="4"/>
                  <c:pt idx="0">
                    <c:v>4.4000000000000004</c:v>
                  </c:pt>
                  <c:pt idx="1">
                    <c:v>3.8</c:v>
                  </c:pt>
                  <c:pt idx="2">
                    <c:v>1.6</c:v>
                  </c:pt>
                  <c:pt idx="3">
                    <c:v>2</c:v>
                  </c:pt>
                </c:numCache>
              </c:numRef>
            </c:plus>
            <c:minus>
              <c:numRef>
                <c:f>'[PSマッチング後_SE別解析（各群７０例）.xlsx]Sheet1'!$H$7:$K$7</c:f>
                <c:numCache>
                  <c:formatCode>General</c:formatCode>
                  <c:ptCount val="4"/>
                  <c:pt idx="0">
                    <c:v>4.4000000000000004</c:v>
                  </c:pt>
                  <c:pt idx="1">
                    <c:v>3.8</c:v>
                  </c:pt>
                  <c:pt idx="2">
                    <c:v>1.6</c:v>
                  </c:pt>
                  <c:pt idx="3">
                    <c:v>2</c:v>
                  </c:pt>
                </c:numCache>
              </c:numRef>
            </c:minus>
            <c:spPr>
              <a:noFill/>
              <a:ln w="19050" cap="flat" cmpd="sng" algn="ctr">
                <a:solidFill>
                  <a:srgbClr val="0070C0"/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H$2:$K$3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H$4:$K$4</c:f>
              <c:numCache>
                <c:formatCode>General</c:formatCode>
                <c:ptCount val="4"/>
                <c:pt idx="0">
                  <c:v>20.238</c:v>
                </c:pt>
                <c:pt idx="1">
                  <c:v>15.148999999999999</c:v>
                </c:pt>
                <c:pt idx="2">
                  <c:v>9.827</c:v>
                </c:pt>
                <c:pt idx="3">
                  <c:v>8.82900000000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3EA-49E6-BCFC-823E3C3EA2E3}"/>
            </c:ext>
          </c:extLst>
        </c:ser>
        <c:ser>
          <c:idx val="1"/>
          <c:order val="1"/>
          <c:tx>
            <c:strRef>
              <c:f>'[PSマッチング後_SE別解析（各群７０例）.xlsx]Sheet1'!$G$5</c:f>
              <c:strCache>
                <c:ptCount val="1"/>
                <c:pt idx="0">
                  <c:v>SE1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H$8:$K$8</c:f>
                <c:numCache>
                  <c:formatCode>General</c:formatCode>
                  <c:ptCount val="4"/>
                  <c:pt idx="0">
                    <c:v>4.0999999999999996</c:v>
                  </c:pt>
                  <c:pt idx="1">
                    <c:v>2.9</c:v>
                  </c:pt>
                  <c:pt idx="2">
                    <c:v>1.9</c:v>
                  </c:pt>
                  <c:pt idx="3">
                    <c:v>1.7</c:v>
                  </c:pt>
                </c:numCache>
              </c:numRef>
            </c:plus>
            <c:minus>
              <c:numRef>
                <c:f>'[PSマッチング後_SE別解析（各群７０例）.xlsx]Sheet1'!$H$8:$K$8</c:f>
                <c:numCache>
                  <c:formatCode>General</c:formatCode>
                  <c:ptCount val="4"/>
                  <c:pt idx="0">
                    <c:v>4.0999999999999996</c:v>
                  </c:pt>
                  <c:pt idx="1">
                    <c:v>2.9</c:v>
                  </c:pt>
                  <c:pt idx="2">
                    <c:v>1.9</c:v>
                  </c:pt>
                  <c:pt idx="3">
                    <c:v>1.7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accent2"/>
                </a:solidFill>
                <a:prstDash val="solid"/>
                <a:miter lim="800000"/>
              </a:ln>
              <a:effectLst/>
            </c:spPr>
          </c:errBars>
          <c:cat>
            <c:strRef>
              <c:f>'[PSマッチング後_SE別解析（各群７０例）.xlsx]Sheet1'!$H$2:$K$3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H$5:$K$5</c:f>
              <c:numCache>
                <c:formatCode>General</c:formatCode>
                <c:ptCount val="4"/>
                <c:pt idx="0">
                  <c:v>21.57</c:v>
                </c:pt>
                <c:pt idx="1">
                  <c:v>13.452999999999999</c:v>
                </c:pt>
                <c:pt idx="2">
                  <c:v>8.8629999999999995</c:v>
                </c:pt>
                <c:pt idx="3">
                  <c:v>6.743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3EA-49E6-BCFC-823E3C3EA2E3}"/>
            </c:ext>
          </c:extLst>
        </c:ser>
        <c:ser>
          <c:idx val="2"/>
          <c:order val="2"/>
          <c:tx>
            <c:strRef>
              <c:f>'[PSマッチング後_SE別解析（各群７０例）.xlsx]Sheet1'!$G$6</c:f>
              <c:strCache>
                <c:ptCount val="1"/>
                <c:pt idx="0">
                  <c:v>SE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PSマッチング後_SE別解析（各群７０例）.xlsx]Sheet1'!$H$9:$K$9</c:f>
                <c:numCache>
                  <c:formatCode>General</c:formatCode>
                  <c:ptCount val="4"/>
                  <c:pt idx="0">
                    <c:v>4.7</c:v>
                  </c:pt>
                  <c:pt idx="1">
                    <c:v>2</c:v>
                  </c:pt>
                  <c:pt idx="2">
                    <c:v>2.7</c:v>
                  </c:pt>
                  <c:pt idx="3">
                    <c:v>2.6</c:v>
                  </c:pt>
                </c:numCache>
              </c:numRef>
            </c:plus>
            <c:minus>
              <c:numRef>
                <c:f>'[PSマッチング後_SE別解析（各群７０例）.xlsx]Sheet1'!$H$9:$K$9</c:f>
                <c:numCache>
                  <c:formatCode>General</c:formatCode>
                  <c:ptCount val="4"/>
                  <c:pt idx="0">
                    <c:v>4.7</c:v>
                  </c:pt>
                  <c:pt idx="1">
                    <c:v>2</c:v>
                  </c:pt>
                  <c:pt idx="2">
                    <c:v>2.7</c:v>
                  </c:pt>
                  <c:pt idx="3">
                    <c:v>2.6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bg1">
                    <a:lumMod val="65000"/>
                  </a:schemeClr>
                </a:solidFill>
                <a:round/>
              </a:ln>
              <a:effectLst/>
            </c:spPr>
          </c:errBars>
          <c:cat>
            <c:strRef>
              <c:f>'[PSマッチング後_SE別解析（各群７０例）.xlsx]Sheet1'!$H$2:$K$3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'[PSマッチング後_SE別解析（各群７０例）.xlsx]Sheet1'!$H$6:$K$6</c:f>
              <c:numCache>
                <c:formatCode>General</c:formatCode>
                <c:ptCount val="4"/>
                <c:pt idx="0">
                  <c:v>19.5</c:v>
                </c:pt>
                <c:pt idx="1">
                  <c:v>7.6909999999999998</c:v>
                </c:pt>
                <c:pt idx="2">
                  <c:v>5.9779999999999998</c:v>
                </c:pt>
                <c:pt idx="3">
                  <c:v>4.692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3EA-49E6-BCFC-823E3C3EA2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7979056"/>
        <c:axId val="537983648"/>
      </c:lineChart>
      <c:catAx>
        <c:axId val="5379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7983648"/>
        <c:crosses val="autoZero"/>
        <c:auto val="1"/>
        <c:lblAlgn val="ctr"/>
        <c:lblOffset val="100"/>
        <c:noMultiLvlLbl val="0"/>
      </c:catAx>
      <c:valAx>
        <c:axId val="5379836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</a:t>
                </a:r>
                <a:r>
                  <a:rPr lang="en-US" altLang="ja-JP" sz="12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DAI</a:t>
                </a:r>
                <a:endParaRPr lang="ja-JP" alt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797905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4.2689018711370664E-3"/>
          <c:y val="0.93525124722005171"/>
          <c:w val="0.78716112098890867"/>
          <c:h val="6.47487527799483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20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facitinib</a:t>
            </a:r>
          </a:p>
        </c:rich>
      </c:tx>
      <c:layout>
        <c:manualLayout>
          <c:xMode val="edge"/>
          <c:yMode val="edge"/>
          <c:x val="0.37361789151356084"/>
          <c:y val="2.31481481481481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SE別CDAI_SDAI_DAS28寛解率.xlsx]DAS28ESR!$B$5</c:f>
              <c:strCache>
                <c:ptCount val="1"/>
                <c:pt idx="0">
                  <c:v>TOF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multiLvlStrRef>
              <c:f>[SE別CDAI_SDAI_DAS28寛解率.xlsx]DAS28ESR!$C$2:$K$4</c:f>
              <c:multiLvlStrCache>
                <c:ptCount val="9"/>
                <c:lvl>
                  <c:pt idx="0">
                    <c:v>4w</c:v>
                  </c:pt>
                  <c:pt idx="1">
                    <c:v>12w</c:v>
                  </c:pt>
                  <c:pt idx="2">
                    <c:v>24w</c:v>
                  </c:pt>
                  <c:pt idx="3">
                    <c:v>4w</c:v>
                  </c:pt>
                  <c:pt idx="4">
                    <c:v>12w</c:v>
                  </c:pt>
                  <c:pt idx="5">
                    <c:v>24w</c:v>
                  </c:pt>
                  <c:pt idx="6">
                    <c:v>4w</c:v>
                  </c:pt>
                  <c:pt idx="7">
                    <c:v>12w</c:v>
                  </c:pt>
                  <c:pt idx="8">
                    <c:v>24w</c:v>
                  </c:pt>
                </c:lvl>
                <c:lvl>
                  <c:pt idx="0">
                    <c:v>SE0</c:v>
                  </c:pt>
                  <c:pt idx="3">
                    <c:v>SE1</c:v>
                  </c:pt>
                  <c:pt idx="6">
                    <c:v>SE2</c:v>
                  </c:pt>
                </c:lvl>
                <c:lvl>
                  <c:pt idx="0">
                    <c:v>n=22</c:v>
                  </c:pt>
                  <c:pt idx="3">
                    <c:v>n=43</c:v>
                  </c:pt>
                  <c:pt idx="6">
                    <c:v>n=5</c:v>
                  </c:pt>
                </c:lvl>
              </c:multiLvlStrCache>
            </c:multiLvlStrRef>
          </c:cat>
          <c:val>
            <c:numRef>
              <c:f>[SE別CDAI_SDAI_DAS28寛解率.xlsx]DAS28ESR!$C$5:$K$5</c:f>
              <c:numCache>
                <c:formatCode>General</c:formatCode>
                <c:ptCount val="9"/>
                <c:pt idx="0">
                  <c:v>50</c:v>
                </c:pt>
                <c:pt idx="1">
                  <c:v>45</c:v>
                </c:pt>
                <c:pt idx="2">
                  <c:v>32</c:v>
                </c:pt>
                <c:pt idx="3">
                  <c:v>16</c:v>
                </c:pt>
                <c:pt idx="4">
                  <c:v>30</c:v>
                </c:pt>
                <c:pt idx="5">
                  <c:v>26</c:v>
                </c:pt>
                <c:pt idx="6">
                  <c:v>40</c:v>
                </c:pt>
                <c:pt idx="7">
                  <c:v>60</c:v>
                </c:pt>
                <c:pt idx="8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D3-4E51-9FB2-B60A8BE6284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4"/>
        <c:axId val="443939648"/>
        <c:axId val="443940632"/>
      </c:barChart>
      <c:catAx>
        <c:axId val="443939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43940632"/>
        <c:crosses val="autoZero"/>
        <c:auto val="1"/>
        <c:lblAlgn val="ctr"/>
        <c:lblOffset val="100"/>
        <c:noMultiLvlLbl val="0"/>
      </c:catAx>
      <c:valAx>
        <c:axId val="443940632"/>
        <c:scaling>
          <c:orientation val="minMax"/>
          <c:max val="6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ortion of patients achieving DAS28-ESR remission  (%)</a:t>
                </a:r>
              </a:p>
            </c:rich>
          </c:tx>
          <c:layout>
            <c:manualLayout>
              <c:xMode val="edge"/>
              <c:yMode val="edge"/>
              <c:x val="1.6666585407474222E-2"/>
              <c:y val="0.196041848935549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4393964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20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atacept</a:t>
            </a:r>
          </a:p>
        </c:rich>
      </c:tx>
      <c:layout>
        <c:manualLayout>
          <c:xMode val="edge"/>
          <c:yMode val="edge"/>
          <c:x val="0.40140266841644801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1493377151822907"/>
          <c:y val="0.13710271882184716"/>
          <c:w val="0.75728865677288693"/>
          <c:h val="0.572788811846280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SE別CDAI_SDAI_DAS28寛解率.xlsx]DAS28ESR!$B$10</c:f>
              <c:strCache>
                <c:ptCount val="1"/>
                <c:pt idx="0">
                  <c:v>AB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multiLvlStrRef>
              <c:f>[SE別CDAI_SDAI_DAS28寛解率.xlsx]DAS28ESR!$C$7:$K$9</c:f>
              <c:multiLvlStrCache>
                <c:ptCount val="9"/>
                <c:lvl>
                  <c:pt idx="0">
                    <c:v>4w</c:v>
                  </c:pt>
                  <c:pt idx="1">
                    <c:v>12w</c:v>
                  </c:pt>
                  <c:pt idx="2">
                    <c:v>24w</c:v>
                  </c:pt>
                  <c:pt idx="3">
                    <c:v>4w</c:v>
                  </c:pt>
                  <c:pt idx="4">
                    <c:v>12w</c:v>
                  </c:pt>
                  <c:pt idx="5">
                    <c:v>24w</c:v>
                  </c:pt>
                  <c:pt idx="6">
                    <c:v>4w</c:v>
                  </c:pt>
                  <c:pt idx="7">
                    <c:v>12w</c:v>
                  </c:pt>
                  <c:pt idx="8">
                    <c:v>24w</c:v>
                  </c:pt>
                </c:lvl>
                <c:lvl>
                  <c:pt idx="0">
                    <c:v>SE0 </c:v>
                  </c:pt>
                  <c:pt idx="3">
                    <c:v>SE1</c:v>
                  </c:pt>
                  <c:pt idx="6">
                    <c:v>SE2</c:v>
                  </c:pt>
                </c:lvl>
                <c:lvl>
                  <c:pt idx="0">
                    <c:v>n=20</c:v>
                  </c:pt>
                  <c:pt idx="3">
                    <c:v>n=38</c:v>
                  </c:pt>
                  <c:pt idx="6">
                    <c:v>n=12</c:v>
                  </c:pt>
                </c:lvl>
              </c:multiLvlStrCache>
            </c:multiLvlStrRef>
          </c:cat>
          <c:val>
            <c:numRef>
              <c:f>[SE別CDAI_SDAI_DAS28寛解率.xlsx]DAS28ESR!$C$10:$K$10</c:f>
              <c:numCache>
                <c:formatCode>General</c:formatCode>
                <c:ptCount val="9"/>
                <c:pt idx="0">
                  <c:v>10</c:v>
                </c:pt>
                <c:pt idx="1">
                  <c:v>5</c:v>
                </c:pt>
                <c:pt idx="2">
                  <c:v>10</c:v>
                </c:pt>
                <c:pt idx="3">
                  <c:v>16</c:v>
                </c:pt>
                <c:pt idx="4">
                  <c:v>29</c:v>
                </c:pt>
                <c:pt idx="5">
                  <c:v>45</c:v>
                </c:pt>
                <c:pt idx="6">
                  <c:v>33</c:v>
                </c:pt>
                <c:pt idx="7">
                  <c:v>58</c:v>
                </c:pt>
                <c:pt idx="8">
                  <c:v>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50-43A5-9E02-9E0E6BAD1B9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4"/>
        <c:axId val="449837272"/>
        <c:axId val="449837600"/>
      </c:barChart>
      <c:catAx>
        <c:axId val="449837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49837600"/>
        <c:crosses val="autoZero"/>
        <c:auto val="1"/>
        <c:lblAlgn val="ctr"/>
        <c:lblOffset val="100"/>
        <c:noMultiLvlLbl val="0"/>
      </c:catAx>
      <c:valAx>
        <c:axId val="449837600"/>
        <c:scaling>
          <c:orientation val="minMax"/>
          <c:max val="6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ortion of patients achieving DAS28-ESR remission (%)</a:t>
                </a:r>
                <a:endParaRPr lang="ja-JP" sz="1200" b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9444444444444445E-2"/>
              <c:y val="9.418999708369786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4983727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62350207272763"/>
          <c:y val="5.3912219305920092E-2"/>
          <c:w val="0.74320947842098528"/>
          <c:h val="0.735588771448012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[EULAR 改善率解析のためのエクセルデータ (version 2).xlsb.xlsx]EULAR_TOF'!$A$10</c:f>
              <c:strCache>
                <c:ptCount val="1"/>
                <c:pt idx="0">
                  <c:v>good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[EULAR 改善率解析のためのエクセルデータ (version 2).xlsb.xlsx]EULAR_TOF'!$B$8:$J$9</c:f>
              <c:multiLvlStrCache>
                <c:ptCount val="9"/>
                <c:lvl>
                  <c:pt idx="0">
                    <c:v>4w</c:v>
                  </c:pt>
                  <c:pt idx="1">
                    <c:v>12w</c:v>
                  </c:pt>
                  <c:pt idx="2">
                    <c:v>24w</c:v>
                  </c:pt>
                  <c:pt idx="3">
                    <c:v>4w</c:v>
                  </c:pt>
                  <c:pt idx="4">
                    <c:v>12w</c:v>
                  </c:pt>
                  <c:pt idx="5">
                    <c:v>24w</c:v>
                  </c:pt>
                  <c:pt idx="6">
                    <c:v>4w</c:v>
                  </c:pt>
                  <c:pt idx="7">
                    <c:v>12w</c:v>
                  </c:pt>
                  <c:pt idx="8">
                    <c:v>24w</c:v>
                  </c:pt>
                </c:lvl>
                <c:lvl>
                  <c:pt idx="0">
                    <c:v>SE 0</c:v>
                  </c:pt>
                  <c:pt idx="3">
                    <c:v>SE 1</c:v>
                  </c:pt>
                  <c:pt idx="6">
                    <c:v>SE 2</c:v>
                  </c:pt>
                </c:lvl>
              </c:multiLvlStrCache>
            </c:multiLvlStrRef>
          </c:cat>
          <c:val>
            <c:numRef>
              <c:f>'[EULAR 改善率解析のためのエクセルデータ (version 2).xlsb.xlsx]EULAR_TOF'!$B$10:$J$10</c:f>
              <c:numCache>
                <c:formatCode>General</c:formatCode>
                <c:ptCount val="9"/>
                <c:pt idx="0">
                  <c:v>50</c:v>
                </c:pt>
                <c:pt idx="1">
                  <c:v>50</c:v>
                </c:pt>
                <c:pt idx="2">
                  <c:v>50</c:v>
                </c:pt>
                <c:pt idx="3">
                  <c:v>26</c:v>
                </c:pt>
                <c:pt idx="4">
                  <c:v>49</c:v>
                </c:pt>
                <c:pt idx="5">
                  <c:v>42</c:v>
                </c:pt>
                <c:pt idx="6">
                  <c:v>40</c:v>
                </c:pt>
                <c:pt idx="7">
                  <c:v>60</c:v>
                </c:pt>
                <c:pt idx="8">
                  <c:v>6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65-4A27-B2F5-FB0A21B8749C}"/>
            </c:ext>
          </c:extLst>
        </c:ser>
        <c:ser>
          <c:idx val="1"/>
          <c:order val="1"/>
          <c:tx>
            <c:strRef>
              <c:f>'[EULAR 改善率解析のためのエクセルデータ (version 2).xlsb.xlsx]EULAR_TOF'!$A$11</c:f>
              <c:strCache>
                <c:ptCount val="1"/>
                <c:pt idx="0">
                  <c:v>moderate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[EULAR 改善率解析のためのエクセルデータ (version 2).xlsb.xlsx]EULAR_TOF'!$B$8:$J$9</c:f>
              <c:multiLvlStrCache>
                <c:ptCount val="9"/>
                <c:lvl>
                  <c:pt idx="0">
                    <c:v>4w</c:v>
                  </c:pt>
                  <c:pt idx="1">
                    <c:v>12w</c:v>
                  </c:pt>
                  <c:pt idx="2">
                    <c:v>24w</c:v>
                  </c:pt>
                  <c:pt idx="3">
                    <c:v>4w</c:v>
                  </c:pt>
                  <c:pt idx="4">
                    <c:v>12w</c:v>
                  </c:pt>
                  <c:pt idx="5">
                    <c:v>24w</c:v>
                  </c:pt>
                  <c:pt idx="6">
                    <c:v>4w</c:v>
                  </c:pt>
                  <c:pt idx="7">
                    <c:v>12w</c:v>
                  </c:pt>
                  <c:pt idx="8">
                    <c:v>24w</c:v>
                  </c:pt>
                </c:lvl>
                <c:lvl>
                  <c:pt idx="0">
                    <c:v>SE 0</c:v>
                  </c:pt>
                  <c:pt idx="3">
                    <c:v>SE 1</c:v>
                  </c:pt>
                  <c:pt idx="6">
                    <c:v>SE 2</c:v>
                  </c:pt>
                </c:lvl>
              </c:multiLvlStrCache>
            </c:multiLvlStrRef>
          </c:cat>
          <c:val>
            <c:numRef>
              <c:f>'[EULAR 改善率解析のためのエクセルデータ (version 2).xlsb.xlsx]EULAR_TOF'!$B$11:$J$11</c:f>
              <c:numCache>
                <c:formatCode>General</c:formatCode>
                <c:ptCount val="9"/>
                <c:pt idx="0">
                  <c:v>23</c:v>
                </c:pt>
                <c:pt idx="1">
                  <c:v>23</c:v>
                </c:pt>
                <c:pt idx="2">
                  <c:v>23</c:v>
                </c:pt>
                <c:pt idx="3">
                  <c:v>47</c:v>
                </c:pt>
                <c:pt idx="4">
                  <c:v>26</c:v>
                </c:pt>
                <c:pt idx="5">
                  <c:v>33</c:v>
                </c:pt>
                <c:pt idx="6">
                  <c:v>20</c:v>
                </c:pt>
                <c:pt idx="7">
                  <c:v>2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165-4A27-B2F5-FB0A21B8749C}"/>
            </c:ext>
          </c:extLst>
        </c:ser>
        <c:ser>
          <c:idx val="2"/>
          <c:order val="2"/>
          <c:tx>
            <c:strRef>
              <c:f>'[EULAR 改善率解析のためのエクセルデータ (version 2).xlsb.xlsx]EULAR_TOF'!$A$12</c:f>
              <c:strCache>
                <c:ptCount val="1"/>
                <c:pt idx="0">
                  <c:v>no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[EULAR 改善率解析のためのエクセルデータ (version 2).xlsb.xlsx]EULAR_TOF'!$B$8:$J$9</c:f>
              <c:multiLvlStrCache>
                <c:ptCount val="9"/>
                <c:lvl>
                  <c:pt idx="0">
                    <c:v>4w</c:v>
                  </c:pt>
                  <c:pt idx="1">
                    <c:v>12w</c:v>
                  </c:pt>
                  <c:pt idx="2">
                    <c:v>24w</c:v>
                  </c:pt>
                  <c:pt idx="3">
                    <c:v>4w</c:v>
                  </c:pt>
                  <c:pt idx="4">
                    <c:v>12w</c:v>
                  </c:pt>
                  <c:pt idx="5">
                    <c:v>24w</c:v>
                  </c:pt>
                  <c:pt idx="6">
                    <c:v>4w</c:v>
                  </c:pt>
                  <c:pt idx="7">
                    <c:v>12w</c:v>
                  </c:pt>
                  <c:pt idx="8">
                    <c:v>24w</c:v>
                  </c:pt>
                </c:lvl>
                <c:lvl>
                  <c:pt idx="0">
                    <c:v>SE 0</c:v>
                  </c:pt>
                  <c:pt idx="3">
                    <c:v>SE 1</c:v>
                  </c:pt>
                  <c:pt idx="6">
                    <c:v>SE 2</c:v>
                  </c:pt>
                </c:lvl>
              </c:multiLvlStrCache>
            </c:multiLvlStrRef>
          </c:cat>
          <c:val>
            <c:numRef>
              <c:f>'[EULAR 改善率解析のためのエクセルデータ (version 2).xlsb.xlsx]EULAR_TOF'!$B$12:$J$12</c:f>
              <c:numCache>
                <c:formatCode>General</c:formatCode>
                <c:ptCount val="9"/>
                <c:pt idx="0">
                  <c:v>27</c:v>
                </c:pt>
                <c:pt idx="1">
                  <c:v>27</c:v>
                </c:pt>
                <c:pt idx="2">
                  <c:v>27</c:v>
                </c:pt>
                <c:pt idx="3">
                  <c:v>27</c:v>
                </c:pt>
                <c:pt idx="4">
                  <c:v>25</c:v>
                </c:pt>
                <c:pt idx="5">
                  <c:v>25</c:v>
                </c:pt>
                <c:pt idx="6">
                  <c:v>40</c:v>
                </c:pt>
                <c:pt idx="7">
                  <c:v>20</c:v>
                </c:pt>
                <c:pt idx="8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165-4A27-B2F5-FB0A21B8749C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523851424"/>
        <c:axId val="523851752"/>
      </c:barChart>
      <c:catAx>
        <c:axId val="523851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23851752"/>
        <c:crosses val="autoZero"/>
        <c:auto val="1"/>
        <c:lblAlgn val="ctr"/>
        <c:lblOffset val="100"/>
        <c:noMultiLvlLbl val="0"/>
      </c:catAx>
      <c:valAx>
        <c:axId val="523851752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ortion</a:t>
                </a:r>
                <a:r>
                  <a:rPr lang="en-US" altLang="ja-JP" sz="12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patients meeting EULAR response criteria (%)</a:t>
                </a:r>
                <a:endParaRPr lang="ja-JP" alt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1111111111111112E-2"/>
              <c:y val="6.01735199766695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2385142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838492055500734"/>
          <c:y val="6.0439586588036075E-2"/>
          <c:w val="0.75230440824053002"/>
          <c:h val="0.6976751659185394"/>
        </c:manualLayout>
      </c:layout>
      <c:lineChart>
        <c:grouping val="standard"/>
        <c:varyColors val="0"/>
        <c:ser>
          <c:idx val="0"/>
          <c:order val="0"/>
          <c:tx>
            <c:strRef>
              <c:f>[CDAI推移の解析.xlsx]CDAI_TOF!$G$24</c:f>
              <c:strCache>
                <c:ptCount val="1"/>
                <c:pt idx="0">
                  <c:v>tofacitinib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CDAI推移の解析.xlsx]CDAI_TOF!$H$26:$K$26</c:f>
                <c:numCache>
                  <c:formatCode>General</c:formatCode>
                  <c:ptCount val="4"/>
                  <c:pt idx="0">
                    <c:v>2.8</c:v>
                  </c:pt>
                  <c:pt idx="1">
                    <c:v>1.6</c:v>
                  </c:pt>
                  <c:pt idx="2">
                    <c:v>1.65</c:v>
                  </c:pt>
                  <c:pt idx="3">
                    <c:v>1.3</c:v>
                  </c:pt>
                </c:numCache>
              </c:numRef>
            </c:plus>
            <c:minus>
              <c:numRef>
                <c:f>[CDAI推移の解析.xlsx]CDAI_TOF!$H$26:$K$26</c:f>
                <c:numCache>
                  <c:formatCode>General</c:formatCode>
                  <c:ptCount val="4"/>
                  <c:pt idx="0">
                    <c:v>2.8</c:v>
                  </c:pt>
                  <c:pt idx="1">
                    <c:v>1.6</c:v>
                  </c:pt>
                  <c:pt idx="2">
                    <c:v>1.65</c:v>
                  </c:pt>
                  <c:pt idx="3">
                    <c:v>1.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CDAI推移の解析.xlsx]CDAI_TOF!$H$23:$K$23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[CDAI推移の解析.xlsx]CDAI_TOF!$H$24:$K$24</c:f>
              <c:numCache>
                <c:formatCode>General</c:formatCode>
                <c:ptCount val="4"/>
                <c:pt idx="0">
                  <c:v>20.3</c:v>
                </c:pt>
                <c:pt idx="1">
                  <c:v>8.5</c:v>
                </c:pt>
                <c:pt idx="2">
                  <c:v>6.4</c:v>
                </c:pt>
                <c:pt idx="3">
                  <c:v>6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A46-4BA3-9553-698B1FA5BD76}"/>
            </c:ext>
          </c:extLst>
        </c:ser>
        <c:ser>
          <c:idx val="1"/>
          <c:order val="1"/>
          <c:tx>
            <c:strRef>
              <c:f>[CDAI推移の解析.xlsx]CDAI_TOF!$G$25</c:f>
              <c:strCache>
                <c:ptCount val="1"/>
                <c:pt idx="0">
                  <c:v>abatacept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CDAI推移の解析.xlsx]CDAI_TOF!$H$27:$K$27</c:f>
                <c:numCache>
                  <c:formatCode>General</c:formatCode>
                  <c:ptCount val="4"/>
                  <c:pt idx="0">
                    <c:v>2.5</c:v>
                  </c:pt>
                  <c:pt idx="1">
                    <c:v>1.95</c:v>
                  </c:pt>
                  <c:pt idx="2">
                    <c:v>1.3</c:v>
                  </c:pt>
                  <c:pt idx="3">
                    <c:v>1.2</c:v>
                  </c:pt>
                </c:numCache>
              </c:numRef>
            </c:plus>
            <c:minus>
              <c:numRef>
                <c:f>[CDAI推移の解析.xlsx]CDAI_TOF!$H$27:$K$27</c:f>
                <c:numCache>
                  <c:formatCode>General</c:formatCode>
                  <c:ptCount val="4"/>
                  <c:pt idx="0">
                    <c:v>2.5</c:v>
                  </c:pt>
                  <c:pt idx="1">
                    <c:v>1.95</c:v>
                  </c:pt>
                  <c:pt idx="2">
                    <c:v>1.3</c:v>
                  </c:pt>
                  <c:pt idx="3">
                    <c:v>1.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bg1">
                    <a:lumMod val="65000"/>
                  </a:schemeClr>
                </a:solidFill>
                <a:round/>
              </a:ln>
              <a:effectLst/>
            </c:spPr>
          </c:errBars>
          <c:cat>
            <c:strRef>
              <c:f>[CDAI推移の解析.xlsx]CDAI_TOF!$H$23:$K$23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[CDAI推移の解析.xlsx]CDAI_TOF!$H$25:$K$25</c:f>
              <c:numCache>
                <c:formatCode>General</c:formatCode>
                <c:ptCount val="4"/>
                <c:pt idx="0">
                  <c:v>19.8</c:v>
                </c:pt>
                <c:pt idx="1">
                  <c:v>12.2</c:v>
                </c:pt>
                <c:pt idx="2">
                  <c:v>8</c:v>
                </c:pt>
                <c:pt idx="3">
                  <c:v>6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A46-4BA3-9553-698B1FA5BD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49259048"/>
        <c:axId val="449267904"/>
      </c:lineChart>
      <c:catAx>
        <c:axId val="449259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49267904"/>
        <c:crosses val="autoZero"/>
        <c:auto val="1"/>
        <c:lblAlgn val="ctr"/>
        <c:lblOffset val="100"/>
        <c:noMultiLvlLbl val="0"/>
      </c:catAx>
      <c:valAx>
        <c:axId val="449267904"/>
        <c:scaling>
          <c:orientation val="minMax"/>
          <c:max val="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CDAI</a:t>
                </a:r>
                <a:endParaRPr lang="ja-JP" altLang="en-US" sz="12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4925904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4.9999798618523071E-2"/>
          <c:y val="0.8617741895709049"/>
          <c:w val="0.9"/>
          <c:h val="0.1052587631992572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055264514243074"/>
          <c:y val="5.3912219305920092E-2"/>
          <c:w val="0.7288915556991532"/>
          <c:h val="0.5996086283919466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[EULAR 改善率解析のためのエクセルデータ (version 2).xlsb.xlsx]EULAR_ABT'!$A$5</c:f>
              <c:strCache>
                <c:ptCount val="1"/>
                <c:pt idx="0">
                  <c:v>good response 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[EULAR 改善率解析のためのエクセルデータ (version 2).xlsb.xlsx]EULAR_ABT'!$B$3:$J$4</c:f>
              <c:multiLvlStrCache>
                <c:ptCount val="9"/>
                <c:lvl>
                  <c:pt idx="0">
                    <c:v>4w</c:v>
                  </c:pt>
                  <c:pt idx="1">
                    <c:v>12w</c:v>
                  </c:pt>
                  <c:pt idx="2">
                    <c:v>24w</c:v>
                  </c:pt>
                  <c:pt idx="3">
                    <c:v>4w</c:v>
                  </c:pt>
                  <c:pt idx="4">
                    <c:v>12w</c:v>
                  </c:pt>
                  <c:pt idx="5">
                    <c:v>24w</c:v>
                  </c:pt>
                  <c:pt idx="6">
                    <c:v>4w</c:v>
                  </c:pt>
                  <c:pt idx="7">
                    <c:v>12w</c:v>
                  </c:pt>
                  <c:pt idx="8">
                    <c:v>24w</c:v>
                  </c:pt>
                </c:lvl>
                <c:lvl>
                  <c:pt idx="0">
                    <c:v>SE 0</c:v>
                  </c:pt>
                  <c:pt idx="3">
                    <c:v>SE 1</c:v>
                  </c:pt>
                  <c:pt idx="6">
                    <c:v>SE 2</c:v>
                  </c:pt>
                </c:lvl>
              </c:multiLvlStrCache>
            </c:multiLvlStrRef>
          </c:cat>
          <c:val>
            <c:numRef>
              <c:f>'[EULAR 改善率解析のためのエクセルデータ (version 2).xlsb.xlsx]EULAR_ABT'!$B$5:$J$5</c:f>
              <c:numCache>
                <c:formatCode>General</c:formatCode>
                <c:ptCount val="9"/>
                <c:pt idx="0">
                  <c:v>5</c:v>
                </c:pt>
                <c:pt idx="1">
                  <c:v>15</c:v>
                </c:pt>
                <c:pt idx="2">
                  <c:v>20</c:v>
                </c:pt>
                <c:pt idx="3">
                  <c:v>21</c:v>
                </c:pt>
                <c:pt idx="4">
                  <c:v>42</c:v>
                </c:pt>
                <c:pt idx="5">
                  <c:v>45</c:v>
                </c:pt>
                <c:pt idx="6">
                  <c:v>42</c:v>
                </c:pt>
                <c:pt idx="7">
                  <c:v>58</c:v>
                </c:pt>
                <c:pt idx="8">
                  <c:v>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65-4667-811B-0B4CCE430BBE}"/>
            </c:ext>
          </c:extLst>
        </c:ser>
        <c:ser>
          <c:idx val="1"/>
          <c:order val="1"/>
          <c:tx>
            <c:strRef>
              <c:f>'[EULAR 改善率解析のためのエクセルデータ (version 2).xlsb.xlsx]EULAR_ABT'!$A$6</c:f>
              <c:strCache>
                <c:ptCount val="1"/>
                <c:pt idx="0">
                  <c:v>moderate response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[EULAR 改善率解析のためのエクセルデータ (version 2).xlsb.xlsx]EULAR_ABT'!$B$3:$J$4</c:f>
              <c:multiLvlStrCache>
                <c:ptCount val="9"/>
                <c:lvl>
                  <c:pt idx="0">
                    <c:v>4w</c:v>
                  </c:pt>
                  <c:pt idx="1">
                    <c:v>12w</c:v>
                  </c:pt>
                  <c:pt idx="2">
                    <c:v>24w</c:v>
                  </c:pt>
                  <c:pt idx="3">
                    <c:v>4w</c:v>
                  </c:pt>
                  <c:pt idx="4">
                    <c:v>12w</c:v>
                  </c:pt>
                  <c:pt idx="5">
                    <c:v>24w</c:v>
                  </c:pt>
                  <c:pt idx="6">
                    <c:v>4w</c:v>
                  </c:pt>
                  <c:pt idx="7">
                    <c:v>12w</c:v>
                  </c:pt>
                  <c:pt idx="8">
                    <c:v>24w</c:v>
                  </c:pt>
                </c:lvl>
                <c:lvl>
                  <c:pt idx="0">
                    <c:v>SE 0</c:v>
                  </c:pt>
                  <c:pt idx="3">
                    <c:v>SE 1</c:v>
                  </c:pt>
                  <c:pt idx="6">
                    <c:v>SE 2</c:v>
                  </c:pt>
                </c:lvl>
              </c:multiLvlStrCache>
            </c:multiLvlStrRef>
          </c:cat>
          <c:val>
            <c:numRef>
              <c:f>'[EULAR 改善率解析のためのエクセルデータ (version 2).xlsb.xlsx]EULAR_ABT'!$B$6:$J$6</c:f>
              <c:numCache>
                <c:formatCode>General</c:formatCode>
                <c:ptCount val="9"/>
                <c:pt idx="0">
                  <c:v>35</c:v>
                </c:pt>
                <c:pt idx="1">
                  <c:v>50</c:v>
                </c:pt>
                <c:pt idx="2">
                  <c:v>55</c:v>
                </c:pt>
                <c:pt idx="3">
                  <c:v>32</c:v>
                </c:pt>
                <c:pt idx="4">
                  <c:v>29</c:v>
                </c:pt>
                <c:pt idx="5">
                  <c:v>34</c:v>
                </c:pt>
                <c:pt idx="6">
                  <c:v>25</c:v>
                </c:pt>
                <c:pt idx="7">
                  <c:v>9</c:v>
                </c:pt>
                <c:pt idx="8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C65-4667-811B-0B4CCE430BBE}"/>
            </c:ext>
          </c:extLst>
        </c:ser>
        <c:ser>
          <c:idx val="2"/>
          <c:order val="2"/>
          <c:tx>
            <c:strRef>
              <c:f>'[EULAR 改善率解析のためのエクセルデータ (version 2).xlsb.xlsx]EULAR_ABT'!$A$7</c:f>
              <c:strCache>
                <c:ptCount val="1"/>
                <c:pt idx="0">
                  <c:v>no response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[EULAR 改善率解析のためのエクセルデータ (version 2).xlsb.xlsx]EULAR_ABT'!$B$3:$J$4</c:f>
              <c:multiLvlStrCache>
                <c:ptCount val="9"/>
                <c:lvl>
                  <c:pt idx="0">
                    <c:v>4w</c:v>
                  </c:pt>
                  <c:pt idx="1">
                    <c:v>12w</c:v>
                  </c:pt>
                  <c:pt idx="2">
                    <c:v>24w</c:v>
                  </c:pt>
                  <c:pt idx="3">
                    <c:v>4w</c:v>
                  </c:pt>
                  <c:pt idx="4">
                    <c:v>12w</c:v>
                  </c:pt>
                  <c:pt idx="5">
                    <c:v>24w</c:v>
                  </c:pt>
                  <c:pt idx="6">
                    <c:v>4w</c:v>
                  </c:pt>
                  <c:pt idx="7">
                    <c:v>12w</c:v>
                  </c:pt>
                  <c:pt idx="8">
                    <c:v>24w</c:v>
                  </c:pt>
                </c:lvl>
                <c:lvl>
                  <c:pt idx="0">
                    <c:v>SE 0</c:v>
                  </c:pt>
                  <c:pt idx="3">
                    <c:v>SE 1</c:v>
                  </c:pt>
                  <c:pt idx="6">
                    <c:v>SE 2</c:v>
                  </c:pt>
                </c:lvl>
              </c:multiLvlStrCache>
            </c:multiLvlStrRef>
          </c:cat>
          <c:val>
            <c:numRef>
              <c:f>'[EULAR 改善率解析のためのエクセルデータ (version 2).xlsb.xlsx]EULAR_ABT'!$B$7:$J$7</c:f>
              <c:numCache>
                <c:formatCode>General</c:formatCode>
                <c:ptCount val="9"/>
                <c:pt idx="0">
                  <c:v>60</c:v>
                </c:pt>
                <c:pt idx="1">
                  <c:v>35</c:v>
                </c:pt>
                <c:pt idx="2">
                  <c:v>25</c:v>
                </c:pt>
                <c:pt idx="3">
                  <c:v>47</c:v>
                </c:pt>
                <c:pt idx="4">
                  <c:v>29</c:v>
                </c:pt>
                <c:pt idx="5">
                  <c:v>21</c:v>
                </c:pt>
                <c:pt idx="6">
                  <c:v>33</c:v>
                </c:pt>
                <c:pt idx="7">
                  <c:v>33</c:v>
                </c:pt>
                <c:pt idx="8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C65-4667-811B-0B4CCE430BBE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549973736"/>
        <c:axId val="549975048"/>
      </c:barChart>
      <c:catAx>
        <c:axId val="549973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49975048"/>
        <c:crosses val="autoZero"/>
        <c:auto val="1"/>
        <c:lblAlgn val="ctr"/>
        <c:lblOffset val="100"/>
        <c:noMultiLvlLbl val="0"/>
      </c:catAx>
      <c:valAx>
        <c:axId val="549975048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ortion of patients meeting </a:t>
                </a:r>
              </a:p>
              <a:p>
                <a:pPr>
                  <a:defRPr sz="12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LAR response criteria (%)</a:t>
                </a:r>
              </a:p>
            </c:rich>
          </c:tx>
          <c:layout>
            <c:manualLayout>
              <c:xMode val="edge"/>
              <c:yMode val="edge"/>
              <c:x val="1.6666666666666666E-2"/>
              <c:y val="4.465296004666083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4997373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5702383974521706"/>
          <c:y val="0.84523316497238343"/>
          <c:w val="0.47743924672867005"/>
          <c:h val="0.1330777320940373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873391465453006"/>
          <c:y val="5.4113161971113564E-2"/>
          <c:w val="0.73500010069073851"/>
          <c:h val="0.68969994503466225"/>
        </c:manualLayout>
      </c:layout>
      <c:lineChart>
        <c:grouping val="standard"/>
        <c:varyColors val="0"/>
        <c:ser>
          <c:idx val="0"/>
          <c:order val="0"/>
          <c:tx>
            <c:strRef>
              <c:f>[SDAIの推移_変化量_ESR_CRPエクセルデータ.xlsx]SDAI_TOF!$G$24</c:f>
              <c:strCache>
                <c:ptCount val="1"/>
                <c:pt idx="0">
                  <c:v>tofacitinib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SDAIの推移_変化量_ESR_CRPエクセルデータ.xlsx]SDAI_TOF!$H$26:$K$26</c:f>
                <c:numCache>
                  <c:formatCode>General</c:formatCode>
                  <c:ptCount val="4"/>
                  <c:pt idx="0">
                    <c:v>3</c:v>
                  </c:pt>
                  <c:pt idx="1">
                    <c:v>1.7</c:v>
                  </c:pt>
                  <c:pt idx="2">
                    <c:v>1.7</c:v>
                  </c:pt>
                  <c:pt idx="3">
                    <c:v>1.4</c:v>
                  </c:pt>
                </c:numCache>
              </c:numRef>
            </c:plus>
            <c:minus>
              <c:numRef>
                <c:f>[SDAIの推移_変化量_ESR_CRPエクセルデータ.xlsx]SDAI_TOF!$H$26:$K$26</c:f>
                <c:numCache>
                  <c:formatCode>General</c:formatCode>
                  <c:ptCount val="4"/>
                  <c:pt idx="0">
                    <c:v>3</c:v>
                  </c:pt>
                  <c:pt idx="1">
                    <c:v>1.7</c:v>
                  </c:pt>
                  <c:pt idx="2">
                    <c:v>1.7</c:v>
                  </c:pt>
                  <c:pt idx="3">
                    <c:v>1.4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SDAIの推移_変化量_ESR_CRPエクセルデータ.xlsx]SDAI_TOF!$H$23:$K$23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[SDAIの推移_変化量_ESR_CRPエクセルデータ.xlsx]SDAI_TOF!$H$24:$K$24</c:f>
              <c:numCache>
                <c:formatCode>General</c:formatCode>
                <c:ptCount val="4"/>
                <c:pt idx="0">
                  <c:v>21.9</c:v>
                </c:pt>
                <c:pt idx="1">
                  <c:v>9.1</c:v>
                </c:pt>
                <c:pt idx="2">
                  <c:v>6.7</c:v>
                </c:pt>
                <c:pt idx="3">
                  <c:v>6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0D7-4B47-BEA3-D5EB28FC1506}"/>
            </c:ext>
          </c:extLst>
        </c:ser>
        <c:ser>
          <c:idx val="1"/>
          <c:order val="1"/>
          <c:tx>
            <c:strRef>
              <c:f>[SDAIの推移_変化量_ESR_CRPエクセルデータ.xlsx]SDAI_TOF!$G$25</c:f>
              <c:strCache>
                <c:ptCount val="1"/>
                <c:pt idx="0">
                  <c:v>abatacept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SDAIの推移_変化量_ESR_CRPエクセルデータ.xlsx]SDAI_TOF!$H$27:$K$27</c:f>
                <c:numCache>
                  <c:formatCode>General</c:formatCode>
                  <c:ptCount val="4"/>
                  <c:pt idx="0">
                    <c:v>2.9</c:v>
                  </c:pt>
                  <c:pt idx="1">
                    <c:v>2.1</c:v>
                  </c:pt>
                  <c:pt idx="2">
                    <c:v>1.3</c:v>
                  </c:pt>
                  <c:pt idx="3">
                    <c:v>1.2</c:v>
                  </c:pt>
                </c:numCache>
              </c:numRef>
            </c:plus>
            <c:minus>
              <c:numRef>
                <c:f>[SDAIの推移_変化量_ESR_CRPエクセルデータ.xlsx]SDAI_TOF!$H$27:$K$27</c:f>
                <c:numCache>
                  <c:formatCode>General</c:formatCode>
                  <c:ptCount val="4"/>
                  <c:pt idx="0">
                    <c:v>2.9</c:v>
                  </c:pt>
                  <c:pt idx="1">
                    <c:v>2.1</c:v>
                  </c:pt>
                  <c:pt idx="2">
                    <c:v>1.3</c:v>
                  </c:pt>
                  <c:pt idx="3">
                    <c:v>1.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bg1">
                    <a:lumMod val="65000"/>
                  </a:schemeClr>
                </a:solidFill>
                <a:round/>
              </a:ln>
              <a:effectLst/>
            </c:spPr>
          </c:errBars>
          <c:cat>
            <c:strRef>
              <c:f>[SDAIの推移_変化量_ESR_CRPエクセルデータ.xlsx]SDAI_TOF!$H$23:$K$23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[SDAIの推移_変化量_ESR_CRPエクセルデータ.xlsx]SDAI_TOF!$H$25:$K$25</c:f>
              <c:numCache>
                <c:formatCode>General</c:formatCode>
                <c:ptCount val="4"/>
                <c:pt idx="0">
                  <c:v>21.3</c:v>
                </c:pt>
                <c:pt idx="1">
                  <c:v>12.9</c:v>
                </c:pt>
                <c:pt idx="2">
                  <c:v>8.6</c:v>
                </c:pt>
                <c:pt idx="3">
                  <c:v>6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0D7-4B47-BEA3-D5EB28FC15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1351344"/>
        <c:axId val="531356920"/>
      </c:lineChart>
      <c:catAx>
        <c:axId val="531351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1356920"/>
        <c:crosses val="autoZero"/>
        <c:auto val="1"/>
        <c:lblAlgn val="ctr"/>
        <c:lblOffset val="100"/>
        <c:noMultiLvlLbl val="0"/>
      </c:catAx>
      <c:valAx>
        <c:axId val="531356920"/>
        <c:scaling>
          <c:orientation val="minMax"/>
          <c:max val="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SDAI</a:t>
                </a:r>
                <a:endParaRPr lang="ja-JP" altLang="en-US" sz="12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135134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684405828581778"/>
          <c:y val="0.10268576144139188"/>
          <c:w val="0.662926056656711"/>
          <c:h val="0.748999071622597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DAS28ESR_CDAI_SDAI平均値の推移.xlsx]Sheet3!$C$11</c:f>
              <c:strCache>
                <c:ptCount val="1"/>
                <c:pt idx="0">
                  <c:v>tofacitini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Ref>
                <c:f>[DAS28ESR_CDAI_SDAI平均値の推移.xlsx]Sheet3!$D$15:$F$15</c:f>
                <c:numCache>
                  <c:formatCode>General</c:formatCode>
                  <c:ptCount val="3"/>
                </c:numCache>
              </c:numRef>
            </c:plus>
            <c:minus>
              <c:numRef>
                <c:f>[DAS28ESR_CDAI_SDAI平均値の推移.xlsx]Sheet3!$D$13:$F$13</c:f>
                <c:numCache>
                  <c:formatCode>General</c:formatCode>
                  <c:ptCount val="3"/>
                  <c:pt idx="0">
                    <c:v>2.8</c:v>
                  </c:pt>
                  <c:pt idx="1">
                    <c:v>3.1</c:v>
                  </c:pt>
                  <c:pt idx="2">
                    <c:v>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DAS28ESR_CDAI_SDAI平均値の推移.xlsx]Sheet3!$D$10:$F$10</c:f>
              <c:strCache>
                <c:ptCount val="3"/>
                <c:pt idx="0">
                  <c:v>4w</c:v>
                </c:pt>
                <c:pt idx="1">
                  <c:v>12w</c:v>
                </c:pt>
                <c:pt idx="2">
                  <c:v>24w</c:v>
                </c:pt>
              </c:strCache>
            </c:strRef>
          </c:cat>
          <c:val>
            <c:numRef>
              <c:f>[DAS28ESR_CDAI_SDAI平均値の推移.xlsx]Sheet3!$D$11:$F$11</c:f>
              <c:numCache>
                <c:formatCode>General</c:formatCode>
                <c:ptCount val="3"/>
                <c:pt idx="0">
                  <c:v>-12.86</c:v>
                </c:pt>
                <c:pt idx="1">
                  <c:v>-15.39</c:v>
                </c:pt>
                <c:pt idx="2">
                  <c:v>-15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66-4124-867F-A58F41A072F3}"/>
            </c:ext>
          </c:extLst>
        </c:ser>
        <c:ser>
          <c:idx val="1"/>
          <c:order val="1"/>
          <c:tx>
            <c:strRef>
              <c:f>[DAS28ESR_CDAI_SDAI平均値の推移.xlsx]Sheet3!$C$12</c:f>
              <c:strCache>
                <c:ptCount val="1"/>
                <c:pt idx="0">
                  <c:v>abatacept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[DAS28ESR_CDAI_SDAI平均値の推移.xlsx]Sheet3!$D$14:$F$14</c:f>
                <c:numCache>
                  <c:formatCode>General</c:formatCode>
                  <c:ptCount val="3"/>
                  <c:pt idx="0">
                    <c:v>2.2000000000000002</c:v>
                  </c:pt>
                  <c:pt idx="1">
                    <c:v>2.5</c:v>
                  </c:pt>
                  <c:pt idx="2">
                    <c:v>2.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DAS28ESR_CDAI_SDAI平均値の推移.xlsx]Sheet3!$D$10:$F$10</c:f>
              <c:strCache>
                <c:ptCount val="3"/>
                <c:pt idx="0">
                  <c:v>4w</c:v>
                </c:pt>
                <c:pt idx="1">
                  <c:v>12w</c:v>
                </c:pt>
                <c:pt idx="2">
                  <c:v>24w</c:v>
                </c:pt>
              </c:strCache>
            </c:strRef>
          </c:cat>
          <c:val>
            <c:numRef>
              <c:f>[DAS28ESR_CDAI_SDAI平均値の推移.xlsx]Sheet3!$D$12:$F$12</c:f>
              <c:numCache>
                <c:formatCode>General</c:formatCode>
                <c:ptCount val="3"/>
                <c:pt idx="0">
                  <c:v>-7.46</c:v>
                </c:pt>
                <c:pt idx="1">
                  <c:v>-11.75</c:v>
                </c:pt>
                <c:pt idx="2">
                  <c:v>-13.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566-4124-867F-A58F41A072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4479656"/>
        <c:axId val="554487200"/>
      </c:barChart>
      <c:catAx>
        <c:axId val="554479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54487200"/>
        <c:crosses val="autoZero"/>
        <c:auto val="1"/>
        <c:lblAlgn val="ctr"/>
        <c:lblOffset val="100"/>
        <c:noMultiLvlLbl val="0"/>
      </c:catAx>
      <c:valAx>
        <c:axId val="5544872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</a:t>
                </a:r>
                <a:r>
                  <a:rPr lang="en-US" altLang="ja-JP" sz="12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hange from baseline score in SDAI</a:t>
                </a:r>
                <a:endParaRPr lang="ja-JP" alt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4.6660566077888911E-2"/>
              <c:y val="0.103573221469587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54479656"/>
        <c:crosses val="autoZero"/>
        <c:crossBetween val="between"/>
        <c:majorUnit val="9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06162273194111"/>
          <c:y val="5.0925925925925923E-2"/>
          <c:w val="0.68891072759127614"/>
          <c:h val="0.70797645086030914"/>
        </c:manualLayout>
      </c:layout>
      <c:lineChart>
        <c:grouping val="standard"/>
        <c:varyColors val="0"/>
        <c:ser>
          <c:idx val="0"/>
          <c:order val="0"/>
          <c:tx>
            <c:strRef>
              <c:f>[DAS28ESR推移の解析.xlsx]DAS28_TOF!$H$17</c:f>
              <c:strCache>
                <c:ptCount val="1"/>
                <c:pt idx="0">
                  <c:v>tofacitinib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DAS28ESR推移の解析.xlsx]DAS28_TOF!$I$19:$L$19</c:f>
                <c:numCache>
                  <c:formatCode>General</c:formatCode>
                  <c:ptCount val="4"/>
                  <c:pt idx="0">
                    <c:v>0.36</c:v>
                  </c:pt>
                  <c:pt idx="1">
                    <c:v>0.32</c:v>
                  </c:pt>
                  <c:pt idx="2">
                    <c:v>0.28999999999999998</c:v>
                  </c:pt>
                  <c:pt idx="3">
                    <c:v>0.25</c:v>
                  </c:pt>
                </c:numCache>
              </c:numRef>
            </c:plus>
            <c:minus>
              <c:numRef>
                <c:f>[DAS28ESR推移の解析.xlsx]DAS28_TOF!$I$19:$L$19</c:f>
                <c:numCache>
                  <c:formatCode>General</c:formatCode>
                  <c:ptCount val="4"/>
                  <c:pt idx="0">
                    <c:v>0.36</c:v>
                  </c:pt>
                  <c:pt idx="1">
                    <c:v>0.32</c:v>
                  </c:pt>
                  <c:pt idx="2">
                    <c:v>0.28999999999999998</c:v>
                  </c:pt>
                  <c:pt idx="3">
                    <c:v>0.2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DAS28ESR推移の解析.xlsx]DAS28_TOF!$I$16:$L$16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[DAS28ESR推移の解析.xlsx]DAS28_TOF!$I$17:$L$17</c:f>
              <c:numCache>
                <c:formatCode>General</c:formatCode>
                <c:ptCount val="4"/>
                <c:pt idx="0">
                  <c:v>4.8099999999999996</c:v>
                </c:pt>
                <c:pt idx="1">
                  <c:v>3.59</c:v>
                </c:pt>
                <c:pt idx="2">
                  <c:v>3.12</c:v>
                </c:pt>
                <c:pt idx="3">
                  <c:v>2.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E6B-4CC2-B7FF-BF005241689A}"/>
            </c:ext>
          </c:extLst>
        </c:ser>
        <c:ser>
          <c:idx val="1"/>
          <c:order val="1"/>
          <c:tx>
            <c:strRef>
              <c:f>[DAS28ESR推移の解析.xlsx]DAS28_TOF!$H$18</c:f>
              <c:strCache>
                <c:ptCount val="1"/>
                <c:pt idx="0">
                  <c:v>abatacept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DAS28ESR推移の解析.xlsx]DAS28_TOF!$I$20:$L$20</c:f>
                <c:numCache>
                  <c:formatCode>General</c:formatCode>
                  <c:ptCount val="4"/>
                  <c:pt idx="0">
                    <c:v>0.31</c:v>
                  </c:pt>
                  <c:pt idx="1">
                    <c:v>0.34</c:v>
                  </c:pt>
                  <c:pt idx="2">
                    <c:v>0.23</c:v>
                  </c:pt>
                  <c:pt idx="3">
                    <c:v>0.25</c:v>
                  </c:pt>
                </c:numCache>
              </c:numRef>
            </c:plus>
            <c:minus>
              <c:numRef>
                <c:f>[DAS28ESR推移の解析.xlsx]DAS28_TOF!$I$20:$L$20</c:f>
                <c:numCache>
                  <c:formatCode>General</c:formatCode>
                  <c:ptCount val="4"/>
                  <c:pt idx="0">
                    <c:v>0.31</c:v>
                  </c:pt>
                  <c:pt idx="1">
                    <c:v>0.34</c:v>
                  </c:pt>
                  <c:pt idx="2">
                    <c:v>0.23</c:v>
                  </c:pt>
                  <c:pt idx="3">
                    <c:v>0.2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bg1">
                    <a:lumMod val="65000"/>
                  </a:schemeClr>
                </a:solidFill>
                <a:round/>
              </a:ln>
              <a:effectLst/>
            </c:spPr>
          </c:errBars>
          <c:cat>
            <c:strRef>
              <c:f>[DAS28ESR推移の解析.xlsx]DAS28_TOF!$I$16:$L$16</c:f>
              <c:strCache>
                <c:ptCount val="4"/>
                <c:pt idx="0">
                  <c:v>0w</c:v>
                </c:pt>
                <c:pt idx="1">
                  <c:v>4w</c:v>
                </c:pt>
                <c:pt idx="2">
                  <c:v>12w</c:v>
                </c:pt>
                <c:pt idx="3">
                  <c:v>24w</c:v>
                </c:pt>
              </c:strCache>
            </c:strRef>
          </c:cat>
          <c:val>
            <c:numRef>
              <c:f>[DAS28ESR推移の解析.xlsx]DAS28_TOF!$I$18:$L$18</c:f>
              <c:numCache>
                <c:formatCode>General</c:formatCode>
                <c:ptCount val="4"/>
                <c:pt idx="0">
                  <c:v>4.67</c:v>
                </c:pt>
                <c:pt idx="1">
                  <c:v>3.86</c:v>
                </c:pt>
                <c:pt idx="2">
                  <c:v>3.22</c:v>
                </c:pt>
                <c:pt idx="3">
                  <c:v>2.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E6B-4CC2-B7FF-BF00524168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4232568"/>
        <c:axId val="534228960"/>
      </c:lineChart>
      <c:catAx>
        <c:axId val="534232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4228960"/>
        <c:crosses val="autoZero"/>
        <c:auto val="1"/>
        <c:lblAlgn val="ctr"/>
        <c:lblOffset val="100"/>
        <c:noMultiLvlLbl val="0"/>
      </c:catAx>
      <c:valAx>
        <c:axId val="534228960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DAS28-ESR</a:t>
                </a:r>
                <a:endParaRPr lang="ja-JP" altLang="en-US" sz="12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423256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19050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368324425768016"/>
          <c:y val="0.10886592300962379"/>
          <c:w val="0.65932193708947007"/>
          <c:h val="0.723740157480314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DAS28ESR_CDAI_SDAI平均値の推移.xlsx]Sheet3!$C$18</c:f>
              <c:strCache>
                <c:ptCount val="1"/>
                <c:pt idx="0">
                  <c:v>tofacitini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[DAS28ESR_CDAI_SDAI平均値の推移.xlsx]Sheet3!$D$20:$F$20</c:f>
                <c:numCache>
                  <c:formatCode>General</c:formatCode>
                  <c:ptCount val="3"/>
                  <c:pt idx="0">
                    <c:v>2.5</c:v>
                  </c:pt>
                  <c:pt idx="1">
                    <c:v>2.9</c:v>
                  </c:pt>
                  <c:pt idx="2">
                    <c:v>2.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DAS28ESR_CDAI_SDAI平均値の推移.xlsx]Sheet3!$D$17:$F$17</c:f>
              <c:strCache>
                <c:ptCount val="3"/>
                <c:pt idx="0">
                  <c:v>4w</c:v>
                </c:pt>
                <c:pt idx="1">
                  <c:v>12w</c:v>
                </c:pt>
                <c:pt idx="2">
                  <c:v>24w</c:v>
                </c:pt>
              </c:strCache>
            </c:strRef>
          </c:cat>
          <c:val>
            <c:numRef>
              <c:f>[DAS28ESR_CDAI_SDAI平均値の推移.xlsx]Sheet3!$D$18:$F$18</c:f>
              <c:numCache>
                <c:formatCode>General</c:formatCode>
                <c:ptCount val="3"/>
                <c:pt idx="0">
                  <c:v>-11.86</c:v>
                </c:pt>
                <c:pt idx="1">
                  <c:v>-14.1</c:v>
                </c:pt>
                <c:pt idx="2">
                  <c:v>-13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F0-46D0-9CCF-0CBCF81AF50D}"/>
            </c:ext>
          </c:extLst>
        </c:ser>
        <c:ser>
          <c:idx val="1"/>
          <c:order val="1"/>
          <c:tx>
            <c:strRef>
              <c:f>[DAS28ESR_CDAI_SDAI平均値の推移.xlsx]Sheet3!$C$19</c:f>
              <c:strCache>
                <c:ptCount val="1"/>
                <c:pt idx="0">
                  <c:v>abatacept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[DAS28ESR_CDAI_SDAI平均値の推移.xlsx]Sheet3!$D$21:$F$21</c:f>
                <c:numCache>
                  <c:formatCode>General</c:formatCode>
                  <c:ptCount val="3"/>
                  <c:pt idx="0">
                    <c:v>1.9</c:v>
                  </c:pt>
                  <c:pt idx="1">
                    <c:v>2.2999999999999998</c:v>
                  </c:pt>
                  <c:pt idx="2">
                    <c:v>2.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DAS28ESR_CDAI_SDAI平均値の推移.xlsx]Sheet3!$D$17:$F$17</c:f>
              <c:strCache>
                <c:ptCount val="3"/>
                <c:pt idx="0">
                  <c:v>4w</c:v>
                </c:pt>
                <c:pt idx="1">
                  <c:v>12w</c:v>
                </c:pt>
                <c:pt idx="2">
                  <c:v>24w</c:v>
                </c:pt>
              </c:strCache>
            </c:strRef>
          </c:cat>
          <c:val>
            <c:numRef>
              <c:f>[DAS28ESR_CDAI_SDAI平均値の推移.xlsx]Sheet3!$D$19:$F$19</c:f>
              <c:numCache>
                <c:formatCode>General</c:formatCode>
                <c:ptCount val="3"/>
                <c:pt idx="0">
                  <c:v>-6.73</c:v>
                </c:pt>
                <c:pt idx="1">
                  <c:v>-10.9</c:v>
                </c:pt>
                <c:pt idx="2">
                  <c:v>-12.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BF0-46D0-9CCF-0CBCF81AF5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9068544"/>
        <c:axId val="539069856"/>
      </c:barChart>
      <c:catAx>
        <c:axId val="5390685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9069856"/>
        <c:crosses val="autoZero"/>
        <c:auto val="1"/>
        <c:lblAlgn val="ctr"/>
        <c:lblOffset val="100"/>
        <c:noMultiLvlLbl val="0"/>
      </c:catAx>
      <c:valAx>
        <c:axId val="539069856"/>
        <c:scaling>
          <c:orientation val="minMax"/>
          <c:min val="-18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</a:t>
                </a:r>
                <a:r>
                  <a:rPr lang="en-US" altLang="ja-JP" sz="12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hange from baseline score in CDAI</a:t>
                </a:r>
                <a:endParaRPr lang="ja-JP" alt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9068544"/>
        <c:crosses val="autoZero"/>
        <c:crossBetween val="between"/>
        <c:majorUnit val="9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facitinib</a:t>
            </a:r>
          </a:p>
        </c:rich>
      </c:tx>
      <c:layout>
        <c:manualLayout>
          <c:xMode val="edge"/>
          <c:yMode val="edge"/>
          <c:x val="0.43280833333333341"/>
          <c:y val="4.899256624605070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32403888888888888"/>
          <c:y val="0.12793345300118208"/>
          <c:w val="0.62052460317460323"/>
          <c:h val="0.71936850400595409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[EULAR 改善率_HAQ=DI解析のためのエクセルデータ.xlsx]EULAR_TOFABT'!$A$3</c:f>
              <c:strCache>
                <c:ptCount val="1"/>
                <c:pt idx="0">
                  <c:v>good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EULAR 改善率_HAQ=DI解析のためのエクセルデータ.xlsx]EULAR_TOFABT'!$B$2:$D$2</c:f>
              <c:numCache>
                <c:formatCode>General</c:formatCode>
                <c:ptCount val="3"/>
                <c:pt idx="0">
                  <c:v>4</c:v>
                </c:pt>
                <c:pt idx="1">
                  <c:v>12</c:v>
                </c:pt>
                <c:pt idx="2">
                  <c:v>24</c:v>
                </c:pt>
              </c:numCache>
            </c:numRef>
          </c:cat>
          <c:val>
            <c:numRef>
              <c:f>'[EULAR 改善率_HAQ=DI解析のためのエクセルデータ.xlsx]EULAR_TOFABT'!$B$3:$D$3</c:f>
              <c:numCache>
                <c:formatCode>General</c:formatCode>
                <c:ptCount val="3"/>
                <c:pt idx="0">
                  <c:v>35</c:v>
                </c:pt>
                <c:pt idx="1">
                  <c:v>51</c:v>
                </c:pt>
                <c:pt idx="2">
                  <c:v>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41-4DBA-9202-70CC95FA5659}"/>
            </c:ext>
          </c:extLst>
        </c:ser>
        <c:ser>
          <c:idx val="1"/>
          <c:order val="1"/>
          <c:tx>
            <c:strRef>
              <c:f>'[EULAR 改善率_HAQ=DI解析のためのエクセルデータ.xlsx]EULAR_TOFABT'!$A$4</c:f>
              <c:strCache>
                <c:ptCount val="1"/>
                <c:pt idx="0">
                  <c:v>moderat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EULAR 改善率_HAQ=DI解析のためのエクセルデータ.xlsx]EULAR_TOFABT'!$B$2:$D$2</c:f>
              <c:numCache>
                <c:formatCode>General</c:formatCode>
                <c:ptCount val="3"/>
                <c:pt idx="0">
                  <c:v>4</c:v>
                </c:pt>
                <c:pt idx="1">
                  <c:v>12</c:v>
                </c:pt>
                <c:pt idx="2">
                  <c:v>24</c:v>
                </c:pt>
              </c:numCache>
            </c:numRef>
          </c:cat>
          <c:val>
            <c:numRef>
              <c:f>'[EULAR 改善率_HAQ=DI解析のためのエクセルデータ.xlsx]EULAR_TOFABT'!$B$4:$D$4</c:f>
              <c:numCache>
                <c:formatCode>General</c:formatCode>
                <c:ptCount val="3"/>
                <c:pt idx="0">
                  <c:v>38</c:v>
                </c:pt>
                <c:pt idx="1">
                  <c:v>28</c:v>
                </c:pt>
                <c:pt idx="2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341-4DBA-9202-70CC95FA5659}"/>
            </c:ext>
          </c:extLst>
        </c:ser>
        <c:ser>
          <c:idx val="2"/>
          <c:order val="2"/>
          <c:tx>
            <c:strRef>
              <c:f>'[EULAR 改善率_HAQ=DI解析のためのエクセルデータ.xlsx]EULAR_TOFABT'!$A$5</c:f>
              <c:strCache>
                <c:ptCount val="1"/>
                <c:pt idx="0">
                  <c:v>no</c:v>
                </c:pt>
              </c:strCache>
            </c:strRef>
          </c:tx>
          <c:spPr>
            <a:solidFill>
              <a:schemeClr val="accent3">
                <a:tint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EULAR 改善率_HAQ=DI解析のためのエクセルデータ.xlsx]EULAR_TOFABT'!$B$2:$D$2</c:f>
              <c:numCache>
                <c:formatCode>General</c:formatCode>
                <c:ptCount val="3"/>
                <c:pt idx="0">
                  <c:v>4</c:v>
                </c:pt>
                <c:pt idx="1">
                  <c:v>12</c:v>
                </c:pt>
                <c:pt idx="2">
                  <c:v>24</c:v>
                </c:pt>
              </c:numCache>
            </c:numRef>
          </c:cat>
          <c:val>
            <c:numRef>
              <c:f>'[EULAR 改善率_HAQ=DI解析のためのエクセルデータ.xlsx]EULAR_TOFABT'!$B$5:$D$5</c:f>
              <c:numCache>
                <c:formatCode>General</c:formatCode>
                <c:ptCount val="3"/>
                <c:pt idx="0">
                  <c:v>27</c:v>
                </c:pt>
                <c:pt idx="1">
                  <c:v>21</c:v>
                </c:pt>
                <c:pt idx="2">
                  <c:v>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341-4DBA-9202-70CC95FA5659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289284264"/>
        <c:axId val="289280656"/>
      </c:barChart>
      <c:catAx>
        <c:axId val="2892842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89280656"/>
        <c:crosses val="autoZero"/>
        <c:auto val="1"/>
        <c:lblAlgn val="ctr"/>
        <c:lblOffset val="100"/>
        <c:noMultiLvlLbl val="0"/>
      </c:catAx>
      <c:valAx>
        <c:axId val="289280656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ortion</a:t>
                </a:r>
                <a:r>
                  <a:rPr lang="en-US" sz="1200" b="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patients  meeting EULAR response criteria (%)</a:t>
                </a:r>
                <a:endParaRPr lang="en-US" sz="1200" b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8928426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facitinib</a:t>
            </a:r>
          </a:p>
        </c:rich>
      </c:tx>
      <c:layout>
        <c:manualLayout>
          <c:xMode val="edge"/>
          <c:yMode val="edge"/>
          <c:x val="0.45173214285714286"/>
          <c:y val="2.64583333333333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SDAI_HAQ_DAS28ESR_CDAI.xlsx]DAS28-ESR'!$B$3</c:f>
              <c:strCache>
                <c:ptCount val="1"/>
                <c:pt idx="0">
                  <c:v>DAS28ESR&lt;2.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SDAI_HAQ_DAS28ESR_CDAI.xlsx]DAS28-ESR'!$C$2:$F$2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'[SDAI_HAQ_DAS28ESR_CDAI.xlsx]DAS28-ESR'!$C$3:$F$3</c:f>
              <c:numCache>
                <c:formatCode>General</c:formatCode>
                <c:ptCount val="4"/>
                <c:pt idx="0">
                  <c:v>9</c:v>
                </c:pt>
                <c:pt idx="1">
                  <c:v>30</c:v>
                </c:pt>
                <c:pt idx="2">
                  <c:v>37</c:v>
                </c:pt>
                <c:pt idx="3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7A-45D2-9DFE-F67026A8D7D3}"/>
            </c:ext>
          </c:extLst>
        </c:ser>
        <c:ser>
          <c:idx val="1"/>
          <c:order val="1"/>
          <c:tx>
            <c:strRef>
              <c:f>'[SDAI_HAQ_DAS28ESR_CDAI.xlsx]DAS28-ESR'!$B$4</c:f>
              <c:strCache>
                <c:ptCount val="1"/>
                <c:pt idx="0">
                  <c:v>2.6≤DAS28ESR&lt;3.2</c:v>
                </c:pt>
              </c:strCache>
            </c:strRef>
          </c:tx>
          <c:spPr>
            <a:solidFill>
              <a:schemeClr val="accent3">
                <a:shade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SDAI_HAQ_DAS28ESR_CDAI.xlsx]DAS28-ESR'!$C$2:$F$2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'[SDAI_HAQ_DAS28ESR_CDAI.xlsx]DAS28-ESR'!$C$4:$F$4</c:f>
              <c:numCache>
                <c:formatCode>General</c:formatCode>
                <c:ptCount val="4"/>
                <c:pt idx="0">
                  <c:v>3</c:v>
                </c:pt>
                <c:pt idx="1">
                  <c:v>19</c:v>
                </c:pt>
                <c:pt idx="2">
                  <c:v>20</c:v>
                </c:pt>
                <c:pt idx="3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57A-45D2-9DFE-F67026A8D7D3}"/>
            </c:ext>
          </c:extLst>
        </c:ser>
        <c:ser>
          <c:idx val="2"/>
          <c:order val="2"/>
          <c:tx>
            <c:strRef>
              <c:f>'[SDAI_HAQ_DAS28ESR_CDAI.xlsx]DAS28-ESR'!$B$5</c:f>
              <c:strCache>
                <c:ptCount val="1"/>
                <c:pt idx="0">
                  <c:v>3.2≤DAS28ESR≤5.1</c:v>
                </c:pt>
              </c:strCache>
            </c:strRef>
          </c:tx>
          <c:spPr>
            <a:solidFill>
              <a:schemeClr val="accent3">
                <a:tint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SDAI_HAQ_DAS28ESR_CDAI.xlsx]DAS28-ESR'!$C$2:$F$2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'[SDAI_HAQ_DAS28ESR_CDAI.xlsx]DAS28-ESR'!$C$5:$F$5</c:f>
              <c:numCache>
                <c:formatCode>General</c:formatCode>
                <c:ptCount val="4"/>
                <c:pt idx="0">
                  <c:v>51</c:v>
                </c:pt>
                <c:pt idx="1">
                  <c:v>42</c:v>
                </c:pt>
                <c:pt idx="2">
                  <c:v>34</c:v>
                </c:pt>
                <c:pt idx="3">
                  <c:v>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57A-45D2-9DFE-F67026A8D7D3}"/>
            </c:ext>
          </c:extLst>
        </c:ser>
        <c:ser>
          <c:idx val="3"/>
          <c:order val="3"/>
          <c:tx>
            <c:strRef>
              <c:f>'[SDAI_HAQ_DAS28ESR_CDAI.xlsx]DAS28-ESR'!$B$6</c:f>
              <c:strCache>
                <c:ptCount val="1"/>
                <c:pt idx="0">
                  <c:v>DAS28ESR&gt;5.1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SDAI_HAQ_DAS28ESR_CDAI.xlsx]DAS28-ESR'!$C$2:$F$2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'[SDAI_HAQ_DAS28ESR_CDAI.xlsx]DAS28-ESR'!$C$6:$F$6</c:f>
              <c:numCache>
                <c:formatCode>General</c:formatCode>
                <c:ptCount val="4"/>
                <c:pt idx="0">
                  <c:v>37</c:v>
                </c:pt>
                <c:pt idx="1">
                  <c:v>9</c:v>
                </c:pt>
                <c:pt idx="2">
                  <c:v>9</c:v>
                </c:pt>
                <c:pt idx="3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57A-45D2-9DFE-F67026A8D7D3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566568128"/>
        <c:axId val="566564848"/>
      </c:barChart>
      <c:catAx>
        <c:axId val="5665681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66564848"/>
        <c:crosses val="autoZero"/>
        <c:auto val="1"/>
        <c:lblAlgn val="ctr"/>
        <c:lblOffset val="100"/>
        <c:noMultiLvlLbl val="0"/>
      </c:catAx>
      <c:valAx>
        <c:axId val="566564848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6656812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atacept</a:t>
            </a:r>
          </a:p>
        </c:rich>
      </c:tx>
      <c:layout>
        <c:manualLayout>
          <c:xMode val="edge"/>
          <c:yMode val="edge"/>
          <c:x val="0.28477134539978904"/>
          <c:y val="3.52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SDAI_HAQ_DAS28ESR_CDAI.xlsx]DAS28-ESR'!$B$10</c:f>
              <c:strCache>
                <c:ptCount val="1"/>
                <c:pt idx="0">
                  <c:v>DAS28-ESR&lt;2.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SDAI_HAQ_DAS28ESR_CDAI.xlsx]DAS28-ESR'!$C$9:$F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'[SDAI_HAQ_DAS28ESR_CDAI.xlsx]DAS28-ESR'!$C$10:$F$10</c:f>
              <c:numCache>
                <c:formatCode>General</c:formatCode>
                <c:ptCount val="4"/>
                <c:pt idx="0">
                  <c:v>6</c:v>
                </c:pt>
                <c:pt idx="1">
                  <c:v>15</c:v>
                </c:pt>
                <c:pt idx="2">
                  <c:v>27</c:v>
                </c:pt>
                <c:pt idx="3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9B-4CCC-A2E2-73FCBCA612AE}"/>
            </c:ext>
          </c:extLst>
        </c:ser>
        <c:ser>
          <c:idx val="1"/>
          <c:order val="1"/>
          <c:tx>
            <c:strRef>
              <c:f>'[SDAI_HAQ_DAS28ESR_CDAI.xlsx]DAS28-ESR'!$B$11</c:f>
              <c:strCache>
                <c:ptCount val="1"/>
                <c:pt idx="0">
                  <c:v>2.6≤DAS28-ESR&lt;3.2</c:v>
                </c:pt>
              </c:strCache>
            </c:strRef>
          </c:tx>
          <c:spPr>
            <a:solidFill>
              <a:schemeClr val="accent3">
                <a:shade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SDAI_HAQ_DAS28ESR_CDAI.xlsx]DAS28-ESR'!$C$9:$F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'[SDAI_HAQ_DAS28ESR_CDAI.xlsx]DAS28-ESR'!$C$11:$F$11</c:f>
              <c:numCache>
                <c:formatCode>General</c:formatCode>
                <c:ptCount val="4"/>
                <c:pt idx="0">
                  <c:v>3</c:v>
                </c:pt>
                <c:pt idx="1">
                  <c:v>16</c:v>
                </c:pt>
                <c:pt idx="2">
                  <c:v>22</c:v>
                </c:pt>
                <c:pt idx="3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19B-4CCC-A2E2-73FCBCA612AE}"/>
            </c:ext>
          </c:extLst>
        </c:ser>
        <c:ser>
          <c:idx val="2"/>
          <c:order val="2"/>
          <c:tx>
            <c:strRef>
              <c:f>'[SDAI_HAQ_DAS28ESR_CDAI.xlsx]DAS28-ESR'!$B$12</c:f>
              <c:strCache>
                <c:ptCount val="1"/>
                <c:pt idx="0">
                  <c:v>3.2≤DAS28-ESR≤5.1</c:v>
                </c:pt>
              </c:strCache>
            </c:strRef>
          </c:tx>
          <c:spPr>
            <a:solidFill>
              <a:schemeClr val="accent3">
                <a:tint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SDAI_HAQ_DAS28ESR_CDAI.xlsx]DAS28-ESR'!$C$9:$F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'[SDAI_HAQ_DAS28ESR_CDAI.xlsx]DAS28-ESR'!$C$12:$F$12</c:f>
              <c:numCache>
                <c:formatCode>General</c:formatCode>
                <c:ptCount val="4"/>
                <c:pt idx="0">
                  <c:v>57</c:v>
                </c:pt>
                <c:pt idx="1">
                  <c:v>50</c:v>
                </c:pt>
                <c:pt idx="2">
                  <c:v>44</c:v>
                </c:pt>
                <c:pt idx="3">
                  <c:v>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19B-4CCC-A2E2-73FCBCA612AE}"/>
            </c:ext>
          </c:extLst>
        </c:ser>
        <c:ser>
          <c:idx val="3"/>
          <c:order val="3"/>
          <c:tx>
            <c:strRef>
              <c:f>'[SDAI_HAQ_DAS28ESR_CDAI.xlsx]DAS28-ESR'!$B$13</c:f>
              <c:strCache>
                <c:ptCount val="1"/>
                <c:pt idx="0">
                  <c:v>DAS28-ESR&gt;5.1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[SDAI_HAQ_DAS28ESR_CDAI.xlsx]DAS28-ESR'!$C$9:$F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'[SDAI_HAQ_DAS28ESR_CDAI.xlsx]DAS28-ESR'!$C$13:$F$13</c:f>
              <c:numCache>
                <c:formatCode>General</c:formatCode>
                <c:ptCount val="4"/>
                <c:pt idx="0">
                  <c:v>34</c:v>
                </c:pt>
                <c:pt idx="1">
                  <c:v>19</c:v>
                </c:pt>
                <c:pt idx="2">
                  <c:v>7</c:v>
                </c:pt>
                <c:pt idx="3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19B-4CCC-A2E2-73FCBCA612AE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566590432"/>
        <c:axId val="566591088"/>
      </c:barChart>
      <c:catAx>
        <c:axId val="5665904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66591088"/>
        <c:crosses val="autoZero"/>
        <c:auto val="1"/>
        <c:lblAlgn val="ctr"/>
        <c:lblOffset val="100"/>
        <c:noMultiLvlLbl val="0"/>
      </c:catAx>
      <c:valAx>
        <c:axId val="566591088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6659043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8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9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charts/style18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charts/style1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932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776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5072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3142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2019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7578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731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4623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3720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6961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4317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ADD79-6C73-4841-B347-017655497D80}" type="datetimeFigureOut">
              <a:rPr kumimoji="1" lang="ja-JP" altLang="en-US" smtClean="0"/>
              <a:t>2021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FD7466-CE4B-4829-830B-66C3093B3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6615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7" Type="http://schemas.openxmlformats.org/officeDocument/2006/relationships/chart" Target="../charts/chart16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5.xml"/><Relationship Id="rId5" Type="http://schemas.openxmlformats.org/officeDocument/2006/relationships/chart" Target="../charts/chart14.xml"/><Relationship Id="rId4" Type="http://schemas.openxmlformats.org/officeDocument/2006/relationships/chart" Target="../charts/chart1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8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2753562-6A63-4DBC-AD50-35FF3662C04B}"/>
              </a:ext>
            </a:extLst>
          </p:cNvPr>
          <p:cNvSpPr txBox="1"/>
          <p:nvPr/>
        </p:nvSpPr>
        <p:spPr>
          <a:xfrm>
            <a:off x="259492" y="345989"/>
            <a:ext cx="1433384" cy="3830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D03D918B-3DAF-45AF-976E-C7EE0E6319B6}"/>
              </a:ext>
            </a:extLst>
          </p:cNvPr>
          <p:cNvSpPr/>
          <p:nvPr/>
        </p:nvSpPr>
        <p:spPr>
          <a:xfrm>
            <a:off x="259492" y="729049"/>
            <a:ext cx="370703" cy="3830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BA55CF0F-D3C2-455A-8B39-F1BFA4D148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0818708"/>
              </p:ext>
            </p:extLst>
          </p:nvPr>
        </p:nvGraphicFramePr>
        <p:xfrm>
          <a:off x="3785115" y="1112109"/>
          <a:ext cx="24511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2F9C9420-8ADC-4665-82B7-39E6386A82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7815753"/>
              </p:ext>
            </p:extLst>
          </p:nvPr>
        </p:nvGraphicFramePr>
        <p:xfrm>
          <a:off x="259492" y="4238370"/>
          <a:ext cx="2482850" cy="25828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18B1335C-2FA9-4AD2-952B-8C836FB5F3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9160370"/>
              </p:ext>
            </p:extLst>
          </p:nvPr>
        </p:nvGraphicFramePr>
        <p:xfrm>
          <a:off x="259492" y="7138082"/>
          <a:ext cx="2482850" cy="25816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41073DC4-631D-45D4-B995-37F26AB7E3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3371676"/>
              </p:ext>
            </p:extLst>
          </p:nvPr>
        </p:nvGraphicFramePr>
        <p:xfrm>
          <a:off x="3785115" y="7138079"/>
          <a:ext cx="2451100" cy="25816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B6DA2A4D-E380-4490-B2AB-A24045EF48C7}"/>
              </a:ext>
            </a:extLst>
          </p:cNvPr>
          <p:cNvCxnSpPr>
            <a:cxnSpLocks/>
          </p:cNvCxnSpPr>
          <p:nvPr/>
        </p:nvCxnSpPr>
        <p:spPr>
          <a:xfrm>
            <a:off x="4633784" y="2644346"/>
            <a:ext cx="29656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C22F0199-DA1E-4225-AD2A-328FEFAE911A}"/>
              </a:ext>
            </a:extLst>
          </p:cNvPr>
          <p:cNvSpPr/>
          <p:nvPr/>
        </p:nvSpPr>
        <p:spPr>
          <a:xfrm>
            <a:off x="4633784" y="2644346"/>
            <a:ext cx="296562" cy="222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39C8349C-7C5F-4F27-BF64-464C257A5FD6}"/>
              </a:ext>
            </a:extLst>
          </p:cNvPr>
          <p:cNvCxnSpPr/>
          <p:nvPr/>
        </p:nvCxnSpPr>
        <p:spPr>
          <a:xfrm>
            <a:off x="4633784" y="8699157"/>
            <a:ext cx="2965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8DF98EFE-6E10-4B05-A6D8-CB70C8861775}"/>
              </a:ext>
            </a:extLst>
          </p:cNvPr>
          <p:cNvSpPr/>
          <p:nvPr/>
        </p:nvSpPr>
        <p:spPr>
          <a:xfrm>
            <a:off x="4633784" y="8699157"/>
            <a:ext cx="296562" cy="27182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3E727FE3-0EEF-4BE1-8703-7024D2A58923}"/>
              </a:ext>
            </a:extLst>
          </p:cNvPr>
          <p:cNvSpPr/>
          <p:nvPr/>
        </p:nvSpPr>
        <p:spPr>
          <a:xfrm>
            <a:off x="1285102" y="5041558"/>
            <a:ext cx="358347" cy="19770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53D65AE2-7118-4C1C-9CC8-33E1208B9EE2}"/>
              </a:ext>
            </a:extLst>
          </p:cNvPr>
          <p:cNvSpPr/>
          <p:nvPr/>
        </p:nvSpPr>
        <p:spPr>
          <a:xfrm>
            <a:off x="1285103" y="7871254"/>
            <a:ext cx="407773" cy="23477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D9689179-F3AA-46D9-9935-1AD2F9A6D639}"/>
              </a:ext>
            </a:extLst>
          </p:cNvPr>
          <p:cNvSpPr/>
          <p:nvPr/>
        </p:nvSpPr>
        <p:spPr>
          <a:xfrm>
            <a:off x="345989" y="3855309"/>
            <a:ext cx="284206" cy="3830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0E46F036-DA00-4E6D-8E5B-DF25AE9428F6}"/>
              </a:ext>
            </a:extLst>
          </p:cNvPr>
          <p:cNvSpPr/>
          <p:nvPr/>
        </p:nvSpPr>
        <p:spPr>
          <a:xfrm>
            <a:off x="345989" y="6821266"/>
            <a:ext cx="275796" cy="31681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200B7F7D-D773-4E7F-92DA-7C6C3BB22F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5886487"/>
              </p:ext>
            </p:extLst>
          </p:nvPr>
        </p:nvGraphicFramePr>
        <p:xfrm>
          <a:off x="259492" y="1112109"/>
          <a:ext cx="24828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EE5F96E-51FA-4D03-A984-0E8DEAA749A9}"/>
              </a:ext>
            </a:extLst>
          </p:cNvPr>
          <p:cNvSpPr txBox="1"/>
          <p:nvPr/>
        </p:nvSpPr>
        <p:spPr>
          <a:xfrm>
            <a:off x="1136822" y="1462221"/>
            <a:ext cx="506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*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E091C523-E980-4F17-B002-4C3518AB51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3059614"/>
              </p:ext>
            </p:extLst>
          </p:nvPr>
        </p:nvGraphicFramePr>
        <p:xfrm>
          <a:off x="3785115" y="4015946"/>
          <a:ext cx="24511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A860DAA6-0758-46C3-8E48-635C46882065}"/>
              </a:ext>
            </a:extLst>
          </p:cNvPr>
          <p:cNvCxnSpPr/>
          <p:nvPr/>
        </p:nvCxnSpPr>
        <p:spPr>
          <a:xfrm>
            <a:off x="4633784" y="6005384"/>
            <a:ext cx="29656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D78F2FD-E4D8-472E-A432-855D31563577}"/>
              </a:ext>
            </a:extLst>
          </p:cNvPr>
          <p:cNvSpPr txBox="1"/>
          <p:nvPr/>
        </p:nvSpPr>
        <p:spPr>
          <a:xfrm>
            <a:off x="4633784" y="6005383"/>
            <a:ext cx="2965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43641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EBB8C24-EA27-4056-A934-F35F429C56B9}"/>
              </a:ext>
            </a:extLst>
          </p:cNvPr>
          <p:cNvSpPr txBox="1"/>
          <p:nvPr/>
        </p:nvSpPr>
        <p:spPr>
          <a:xfrm>
            <a:off x="185351" y="247135"/>
            <a:ext cx="2730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BC828DC6-5DDF-456B-B426-012BDA6B38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0812997"/>
              </p:ext>
            </p:extLst>
          </p:nvPr>
        </p:nvGraphicFramePr>
        <p:xfrm>
          <a:off x="322055" y="5249562"/>
          <a:ext cx="2520000" cy="2855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827ABD-AE75-4F72-B2EF-CEF672D00F6C}"/>
              </a:ext>
            </a:extLst>
          </p:cNvPr>
          <p:cNvSpPr txBox="1"/>
          <p:nvPr/>
        </p:nvSpPr>
        <p:spPr>
          <a:xfrm>
            <a:off x="92675" y="799299"/>
            <a:ext cx="432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6D637D7-519E-409E-8A52-E02490818725}"/>
              </a:ext>
            </a:extLst>
          </p:cNvPr>
          <p:cNvSpPr txBox="1"/>
          <p:nvPr/>
        </p:nvSpPr>
        <p:spPr>
          <a:xfrm>
            <a:off x="191799" y="4400835"/>
            <a:ext cx="4324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F935AD48-1507-4890-B59E-DF07952CE0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248429"/>
              </p:ext>
            </p:extLst>
          </p:nvPr>
        </p:nvGraphicFramePr>
        <p:xfrm>
          <a:off x="408041" y="1344733"/>
          <a:ext cx="25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21A82B36-0CA6-4A8A-9425-7421D76526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8772040"/>
              </p:ext>
            </p:extLst>
          </p:nvPr>
        </p:nvGraphicFramePr>
        <p:xfrm>
          <a:off x="2928041" y="1344733"/>
          <a:ext cx="3857084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212F43C8-284F-4F94-AD75-9121EE627A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6308192"/>
              </p:ext>
            </p:extLst>
          </p:nvPr>
        </p:nvGraphicFramePr>
        <p:xfrm>
          <a:off x="3100595" y="5249562"/>
          <a:ext cx="3684530" cy="2855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153499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5E920D4-D52E-4B0F-BD82-3546806D0743}"/>
              </a:ext>
            </a:extLst>
          </p:cNvPr>
          <p:cNvSpPr txBox="1"/>
          <p:nvPr/>
        </p:nvSpPr>
        <p:spPr>
          <a:xfrm>
            <a:off x="111211" y="222422"/>
            <a:ext cx="1037967" cy="383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 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3FE9917B-130A-489A-91F5-EC11C6B18D5E}"/>
              </a:ext>
            </a:extLst>
          </p:cNvPr>
          <p:cNvSpPr/>
          <p:nvPr/>
        </p:nvSpPr>
        <p:spPr>
          <a:xfrm>
            <a:off x="4298554" y="1547195"/>
            <a:ext cx="767716" cy="44957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 †*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500F7814-96D9-423F-BC77-8028C17F5696}"/>
              </a:ext>
            </a:extLst>
          </p:cNvPr>
          <p:cNvSpPr/>
          <p:nvPr/>
        </p:nvSpPr>
        <p:spPr>
          <a:xfrm>
            <a:off x="4724307" y="1728342"/>
            <a:ext cx="832561" cy="56006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**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1C75F9E2-81B3-4476-BA00-F2FD24871A8A}"/>
              </a:ext>
            </a:extLst>
          </p:cNvPr>
          <p:cNvSpPr/>
          <p:nvPr/>
        </p:nvSpPr>
        <p:spPr>
          <a:xfrm>
            <a:off x="5348756" y="1954878"/>
            <a:ext cx="633865" cy="31876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0AAC21C-9A6D-4E7F-BFF9-CC199A0DF805}"/>
              </a:ext>
            </a:extLst>
          </p:cNvPr>
          <p:cNvSpPr txBox="1"/>
          <p:nvPr/>
        </p:nvSpPr>
        <p:spPr>
          <a:xfrm>
            <a:off x="4377381" y="7839104"/>
            <a:ext cx="8618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D69011A-4A6F-48AE-8D4E-8FF443324B29}"/>
              </a:ext>
            </a:extLst>
          </p:cNvPr>
          <p:cNvSpPr txBox="1"/>
          <p:nvPr/>
        </p:nvSpPr>
        <p:spPr>
          <a:xfrm>
            <a:off x="4819136" y="8130745"/>
            <a:ext cx="7908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86FD691-79FA-45B7-A176-C3F8AE6AC8F9}"/>
              </a:ext>
            </a:extLst>
          </p:cNvPr>
          <p:cNvSpPr txBox="1"/>
          <p:nvPr/>
        </p:nvSpPr>
        <p:spPr>
          <a:xfrm>
            <a:off x="5325762" y="8283949"/>
            <a:ext cx="9020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026CEB9-7E53-46E6-8C80-015942FC8760}"/>
              </a:ext>
            </a:extLst>
          </p:cNvPr>
          <p:cNvSpPr txBox="1"/>
          <p:nvPr/>
        </p:nvSpPr>
        <p:spPr>
          <a:xfrm>
            <a:off x="197708" y="787260"/>
            <a:ext cx="4324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5FDC134-12C9-4D5F-844D-708BB8AC8436}"/>
              </a:ext>
            </a:extLst>
          </p:cNvPr>
          <p:cNvSpPr txBox="1"/>
          <p:nvPr/>
        </p:nvSpPr>
        <p:spPr>
          <a:xfrm>
            <a:off x="197709" y="3831072"/>
            <a:ext cx="432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786B7A6-32FA-4B19-A606-4CAC5A541BC8}"/>
              </a:ext>
            </a:extLst>
          </p:cNvPr>
          <p:cNvSpPr txBox="1"/>
          <p:nvPr/>
        </p:nvSpPr>
        <p:spPr>
          <a:xfrm>
            <a:off x="254196" y="6897724"/>
            <a:ext cx="3759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46E57EC-E0BB-4B48-84A8-D147888C4737}"/>
              </a:ext>
            </a:extLst>
          </p:cNvPr>
          <p:cNvSpPr txBox="1"/>
          <p:nvPr/>
        </p:nvSpPr>
        <p:spPr>
          <a:xfrm>
            <a:off x="4493634" y="4849423"/>
            <a:ext cx="5726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A6DF7E3-D1CB-4DDB-AD9F-5304529A5302}"/>
              </a:ext>
            </a:extLst>
          </p:cNvPr>
          <p:cNvSpPr txBox="1"/>
          <p:nvPr/>
        </p:nvSpPr>
        <p:spPr>
          <a:xfrm>
            <a:off x="4917988" y="5216392"/>
            <a:ext cx="691979" cy="340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BAA5156-3BA0-47EB-B176-A77C4D65DCDC}"/>
              </a:ext>
            </a:extLst>
          </p:cNvPr>
          <p:cNvSpPr txBox="1"/>
          <p:nvPr/>
        </p:nvSpPr>
        <p:spPr>
          <a:xfrm>
            <a:off x="5436971" y="5397539"/>
            <a:ext cx="691979" cy="340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*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501F6449-FC17-4A19-955A-F64C2D89F0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4583079"/>
              </p:ext>
            </p:extLst>
          </p:nvPr>
        </p:nvGraphicFramePr>
        <p:xfrm>
          <a:off x="630190" y="1150683"/>
          <a:ext cx="2798810" cy="26803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F2F31BA8-2AC7-42B7-BAA9-FC5F0DF42D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4502584"/>
              </p:ext>
            </p:extLst>
          </p:nvPr>
        </p:nvGraphicFramePr>
        <p:xfrm>
          <a:off x="630191" y="4014582"/>
          <a:ext cx="2482850" cy="2914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10F44037-67B2-4C93-8321-6BB8BCC22D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5265500"/>
              </p:ext>
            </p:extLst>
          </p:nvPr>
        </p:nvGraphicFramePr>
        <p:xfrm>
          <a:off x="630190" y="7011858"/>
          <a:ext cx="2798810" cy="28255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7CB55E5A-899F-49B4-A070-E8EADCF11D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5981694"/>
              </p:ext>
            </p:extLst>
          </p:nvPr>
        </p:nvGraphicFramePr>
        <p:xfrm>
          <a:off x="3614295" y="1150682"/>
          <a:ext cx="2607386" cy="26803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D9280625-4634-467A-8A74-5E0DAE50A8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6061813"/>
              </p:ext>
            </p:extLst>
          </p:nvPr>
        </p:nvGraphicFramePr>
        <p:xfrm>
          <a:off x="3545523" y="4012216"/>
          <a:ext cx="2676158" cy="2810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CF7BC0AE-05E9-4905-A6F7-3DD4808CFE5C}"/>
              </a:ext>
            </a:extLst>
          </p:cNvPr>
          <p:cNvSpPr/>
          <p:nvPr/>
        </p:nvSpPr>
        <p:spPr>
          <a:xfrm>
            <a:off x="4493634" y="4805203"/>
            <a:ext cx="572636" cy="338554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F23F3D44-4FF4-46AE-B8E7-AB12624EA97A}"/>
              </a:ext>
            </a:extLst>
          </p:cNvPr>
          <p:cNvSpPr/>
          <p:nvPr/>
        </p:nvSpPr>
        <p:spPr>
          <a:xfrm>
            <a:off x="4917988" y="5214411"/>
            <a:ext cx="691980" cy="265207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***</a:t>
            </a:r>
            <a:endParaRPr kumimoji="1" lang="ja-JP" altLang="en-US" dirty="0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02505506-8A13-4472-BB05-BE2E16397E52}"/>
              </a:ext>
            </a:extLst>
          </p:cNvPr>
          <p:cNvSpPr/>
          <p:nvPr/>
        </p:nvSpPr>
        <p:spPr>
          <a:xfrm>
            <a:off x="5436972" y="5395558"/>
            <a:ext cx="545650" cy="16175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**</a:t>
            </a:r>
            <a:endParaRPr kumimoji="1" lang="ja-JP" altLang="en-US" dirty="0"/>
          </a:p>
        </p:txBody>
      </p:sp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EF406EE2-F84F-4FC3-A753-91B59A7B1C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1842072"/>
              </p:ext>
            </p:extLst>
          </p:nvPr>
        </p:nvGraphicFramePr>
        <p:xfrm>
          <a:off x="3614295" y="6912547"/>
          <a:ext cx="2607386" cy="27749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11750773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26389CB7-D36B-46BF-8E19-C2BE4026A9C2}"/>
              </a:ext>
            </a:extLst>
          </p:cNvPr>
          <p:cNvSpPr/>
          <p:nvPr/>
        </p:nvSpPr>
        <p:spPr>
          <a:xfrm>
            <a:off x="689397" y="992386"/>
            <a:ext cx="530125" cy="39541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26389CB7-D36B-46BF-8E19-C2BE4026A9C2}"/>
              </a:ext>
            </a:extLst>
          </p:cNvPr>
          <p:cNvSpPr/>
          <p:nvPr/>
        </p:nvSpPr>
        <p:spPr>
          <a:xfrm>
            <a:off x="3760364" y="992384"/>
            <a:ext cx="530125" cy="39541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0C61B46-DD40-445D-9C6F-29264D41C13A}"/>
              </a:ext>
            </a:extLst>
          </p:cNvPr>
          <p:cNvSpPr txBox="1"/>
          <p:nvPr/>
        </p:nvSpPr>
        <p:spPr>
          <a:xfrm>
            <a:off x="136133" y="234778"/>
            <a:ext cx="10833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9526692A-2F4B-49FF-ABE0-41173F4F22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3364805"/>
              </p:ext>
            </p:extLst>
          </p:nvPr>
        </p:nvGraphicFramePr>
        <p:xfrm>
          <a:off x="111210" y="1387797"/>
          <a:ext cx="3260087" cy="3829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336FFC53-9DBD-49ED-93E8-715DB474CA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7483656"/>
              </p:ext>
            </p:extLst>
          </p:nvPr>
        </p:nvGraphicFramePr>
        <p:xfrm>
          <a:off x="3511626" y="1387797"/>
          <a:ext cx="3235164" cy="3829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9514318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1831A6C-838D-4235-A115-858518B7C802}"/>
              </a:ext>
            </a:extLst>
          </p:cNvPr>
          <p:cNvSpPr txBox="1"/>
          <p:nvPr/>
        </p:nvSpPr>
        <p:spPr>
          <a:xfrm rot="10800000" flipV="1">
            <a:off x="4374291" y="1611944"/>
            <a:ext cx="2089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atacept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26389CB7-D36B-46BF-8E19-C2BE4026A9C2}"/>
              </a:ext>
            </a:extLst>
          </p:cNvPr>
          <p:cNvSpPr/>
          <p:nvPr/>
        </p:nvSpPr>
        <p:spPr>
          <a:xfrm>
            <a:off x="394434" y="1214927"/>
            <a:ext cx="530125" cy="40380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26389CB7-D36B-46BF-8E19-C2BE4026A9C2}"/>
              </a:ext>
            </a:extLst>
          </p:cNvPr>
          <p:cNvSpPr/>
          <p:nvPr/>
        </p:nvSpPr>
        <p:spPr>
          <a:xfrm>
            <a:off x="3582968" y="1214926"/>
            <a:ext cx="530125" cy="40380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C62F1D46-1B17-4E97-BECC-BE652098C5E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4023167"/>
              </p:ext>
            </p:extLst>
          </p:nvPr>
        </p:nvGraphicFramePr>
        <p:xfrm>
          <a:off x="113320" y="2022542"/>
          <a:ext cx="3249824" cy="29304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E3D84D6A-260B-476F-B0CF-808879FF1128}"/>
              </a:ext>
            </a:extLst>
          </p:cNvPr>
          <p:cNvSpPr/>
          <p:nvPr/>
        </p:nvSpPr>
        <p:spPr>
          <a:xfrm>
            <a:off x="1396314" y="1618735"/>
            <a:ext cx="1248645" cy="40380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facitini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045FC19-EF0C-4ECC-8E10-8626B3FD7EB9}"/>
              </a:ext>
            </a:extLst>
          </p:cNvPr>
          <p:cNvSpPr txBox="1"/>
          <p:nvPr/>
        </p:nvSpPr>
        <p:spPr>
          <a:xfrm>
            <a:off x="113320" y="494270"/>
            <a:ext cx="1134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7486741A-D974-48F0-B0B4-54B8CC2C5A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7075035"/>
              </p:ext>
            </p:extLst>
          </p:nvPr>
        </p:nvGraphicFramePr>
        <p:xfrm>
          <a:off x="3494858" y="2022541"/>
          <a:ext cx="3249825" cy="35132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061429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8</TotalTime>
  <Words>155</Words>
  <Application>Microsoft Office PowerPoint</Application>
  <PresentationFormat>A4 210 x 297 mm</PresentationFormat>
  <Paragraphs>74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恒</dc:creator>
  <cp:lastModifiedBy>廣瀬 恒</cp:lastModifiedBy>
  <cp:revision>228</cp:revision>
  <cp:lastPrinted>2020-12-13T03:22:13Z</cp:lastPrinted>
  <dcterms:created xsi:type="dcterms:W3CDTF">2020-11-05T13:51:09Z</dcterms:created>
  <dcterms:modified xsi:type="dcterms:W3CDTF">2021-07-25T05:50:53Z</dcterms:modified>
</cp:coreProperties>
</file>